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9"/>
  </p:notesMasterIdLst>
  <p:sldIdLst>
    <p:sldId id="357" r:id="rId5"/>
    <p:sldId id="270" r:id="rId6"/>
    <p:sldId id="269" r:id="rId7"/>
    <p:sldId id="358" r:id="rId8"/>
  </p:sldIdLst>
  <p:sldSz cx="7559675" cy="10691813"/>
  <p:notesSz cx="6735763" cy="98663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annan Yang" initials="NY" lastIdx="1" clrIdx="0">
    <p:extLst>
      <p:ext uri="{19B8F6BF-5375-455C-9EA6-DF929625EA0E}">
        <p15:presenceInfo xmlns:p15="http://schemas.microsoft.com/office/powerpoint/2012/main" userId="S::nannan.yang@dpie.nsw.gov.au::8c3b9c4b-18b4-464d-ad2a-754aea970d3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3F0A2AA-337F-4EDA-A85A-13083B4D8B6D}" v="13" dt="2022-06-01T02:27:25.98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381" autoAdjust="0"/>
    <p:restoredTop sz="96149" autoAdjust="0"/>
  </p:normalViewPr>
  <p:slideViewPr>
    <p:cSldViewPr>
      <p:cViewPr varScale="1">
        <p:scale>
          <a:sx n="85" d="100"/>
          <a:sy n="85" d="100"/>
        </p:scale>
        <p:origin x="3161" y="82"/>
      </p:cViewPr>
      <p:guideLst>
        <p:guide orient="horz" pos="3368"/>
        <p:guide pos="2381"/>
      </p:guideLst>
    </p:cSldViewPr>
  </p:slideViewPr>
  <p:outlineViewPr>
    <p:cViewPr>
      <p:scale>
        <a:sx n="33" d="100"/>
        <a:sy n="33" d="100"/>
      </p:scale>
      <p:origin x="0" y="-6427"/>
    </p:cViewPr>
  </p:outlineViewPr>
  <p:notesTextViewPr>
    <p:cViewPr>
      <p:scale>
        <a:sx n="33" d="100"/>
        <a:sy n="33" d="100"/>
      </p:scale>
      <p:origin x="0" y="0"/>
    </p:cViewPr>
  </p:notesTextViewPr>
  <p:notesViewPr>
    <p:cSldViewPr>
      <p:cViewPr varScale="1">
        <p:scale>
          <a:sx n="59" d="100"/>
          <a:sy n="59" d="100"/>
        </p:scale>
        <p:origin x="3245" y="62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microsoft.com/office/2016/11/relationships/changesInfo" Target="changesInfos/changesInfo1.xml"/><Relationship Id="rId10" Type="http://schemas.openxmlformats.org/officeDocument/2006/relationships/commentAuthors" Target="commentAuthors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annan Yang" userId="8c3b9c4b-18b4-464d-ad2a-754aea970d34" providerId="ADAL" clId="{42A03141-E764-4934-9602-96E5E4C1DB98}"/>
    <pc:docChg chg="undo custSel delSld modSld">
      <pc:chgData name="Nannan Yang" userId="8c3b9c4b-18b4-464d-ad2a-754aea970d34" providerId="ADAL" clId="{42A03141-E764-4934-9602-96E5E4C1DB98}" dt="2021-09-20T06:42:11.605" v="560" actId="113"/>
      <pc:docMkLst>
        <pc:docMk/>
      </pc:docMkLst>
      <pc:sldChg chg="del">
        <pc:chgData name="Nannan Yang" userId="8c3b9c4b-18b4-464d-ad2a-754aea970d34" providerId="ADAL" clId="{42A03141-E764-4934-9602-96E5E4C1DB98}" dt="2021-08-10T01:21:51.365" v="1" actId="2696"/>
        <pc:sldMkLst>
          <pc:docMk/>
          <pc:sldMk cId="332727172" sldId="256"/>
        </pc:sldMkLst>
      </pc:sldChg>
      <pc:sldChg chg="del">
        <pc:chgData name="Nannan Yang" userId="8c3b9c4b-18b4-464d-ad2a-754aea970d34" providerId="ADAL" clId="{42A03141-E764-4934-9602-96E5E4C1DB98}" dt="2021-08-10T01:21:51.545" v="11" actId="2696"/>
        <pc:sldMkLst>
          <pc:docMk/>
          <pc:sldMk cId="4063748512" sldId="258"/>
        </pc:sldMkLst>
      </pc:sldChg>
      <pc:sldChg chg="del">
        <pc:chgData name="Nannan Yang" userId="8c3b9c4b-18b4-464d-ad2a-754aea970d34" providerId="ADAL" clId="{42A03141-E764-4934-9602-96E5E4C1DB98}" dt="2021-08-10T01:21:51.440" v="5" actId="2696"/>
        <pc:sldMkLst>
          <pc:docMk/>
          <pc:sldMk cId="1384922134" sldId="259"/>
        </pc:sldMkLst>
      </pc:sldChg>
      <pc:sldChg chg="del">
        <pc:chgData name="Nannan Yang" userId="8c3b9c4b-18b4-464d-ad2a-754aea970d34" providerId="ADAL" clId="{42A03141-E764-4934-9602-96E5E4C1DB98}" dt="2021-08-10T01:21:51.701" v="19" actId="2696"/>
        <pc:sldMkLst>
          <pc:docMk/>
          <pc:sldMk cId="508591034" sldId="260"/>
        </pc:sldMkLst>
      </pc:sldChg>
      <pc:sldChg chg="del">
        <pc:chgData name="Nannan Yang" userId="8c3b9c4b-18b4-464d-ad2a-754aea970d34" providerId="ADAL" clId="{42A03141-E764-4934-9602-96E5E4C1DB98}" dt="2021-08-10T01:21:51.803" v="25" actId="2696"/>
        <pc:sldMkLst>
          <pc:docMk/>
          <pc:sldMk cId="765483863" sldId="261"/>
        </pc:sldMkLst>
      </pc:sldChg>
      <pc:sldChg chg="del">
        <pc:chgData name="Nannan Yang" userId="8c3b9c4b-18b4-464d-ad2a-754aea970d34" providerId="ADAL" clId="{42A03141-E764-4934-9602-96E5E4C1DB98}" dt="2021-08-10T01:21:51.491" v="8" actId="2696"/>
        <pc:sldMkLst>
          <pc:docMk/>
          <pc:sldMk cId="4263079923" sldId="263"/>
        </pc:sldMkLst>
      </pc:sldChg>
      <pc:sldChg chg="del">
        <pc:chgData name="Nannan Yang" userId="8c3b9c4b-18b4-464d-ad2a-754aea970d34" providerId="ADAL" clId="{42A03141-E764-4934-9602-96E5E4C1DB98}" dt="2021-08-10T01:21:51.722" v="20" actId="2696"/>
        <pc:sldMkLst>
          <pc:docMk/>
          <pc:sldMk cId="3622910205" sldId="264"/>
        </pc:sldMkLst>
      </pc:sldChg>
      <pc:sldChg chg="del">
        <pc:chgData name="Nannan Yang" userId="8c3b9c4b-18b4-464d-ad2a-754aea970d34" providerId="ADAL" clId="{42A03141-E764-4934-9602-96E5E4C1DB98}" dt="2021-08-10T01:21:51.756" v="22" actId="2696"/>
        <pc:sldMkLst>
          <pc:docMk/>
          <pc:sldMk cId="4269679052" sldId="265"/>
        </pc:sldMkLst>
      </pc:sldChg>
      <pc:sldChg chg="del">
        <pc:chgData name="Nannan Yang" userId="8c3b9c4b-18b4-464d-ad2a-754aea970d34" providerId="ADAL" clId="{42A03141-E764-4934-9602-96E5E4C1DB98}" dt="2021-08-10T01:21:51.771" v="23" actId="2696"/>
        <pc:sldMkLst>
          <pc:docMk/>
          <pc:sldMk cId="3641098779" sldId="266"/>
        </pc:sldMkLst>
      </pc:sldChg>
      <pc:sldChg chg="del">
        <pc:chgData name="Nannan Yang" userId="8c3b9c4b-18b4-464d-ad2a-754aea970d34" providerId="ADAL" clId="{42A03141-E764-4934-9602-96E5E4C1DB98}" dt="2021-08-10T01:21:51.818" v="26" actId="2696"/>
        <pc:sldMkLst>
          <pc:docMk/>
          <pc:sldMk cId="2345708427" sldId="267"/>
        </pc:sldMkLst>
      </pc:sldChg>
      <pc:sldChg chg="del">
        <pc:chgData name="Nannan Yang" userId="8c3b9c4b-18b4-464d-ad2a-754aea970d34" providerId="ADAL" clId="{42A03141-E764-4934-9602-96E5E4C1DB98}" dt="2021-08-10T01:21:51.348" v="0" actId="2696"/>
        <pc:sldMkLst>
          <pc:docMk/>
          <pc:sldMk cId="3054867221" sldId="268"/>
        </pc:sldMkLst>
      </pc:sldChg>
      <pc:sldChg chg="addSp modSp">
        <pc:chgData name="Nannan Yang" userId="8c3b9c4b-18b4-464d-ad2a-754aea970d34" providerId="ADAL" clId="{42A03141-E764-4934-9602-96E5E4C1DB98}" dt="2021-09-20T06:42:11.605" v="560" actId="113"/>
        <pc:sldMkLst>
          <pc:docMk/>
          <pc:sldMk cId="1287737704" sldId="269"/>
        </pc:sldMkLst>
        <pc:spChg chg="mod">
          <ac:chgData name="Nannan Yang" userId="8c3b9c4b-18b4-464d-ad2a-754aea970d34" providerId="ADAL" clId="{42A03141-E764-4934-9602-96E5E4C1DB98}" dt="2021-09-06T11:54:42.472" v="159" actId="14100"/>
          <ac:spMkLst>
            <pc:docMk/>
            <pc:sldMk cId="1287737704" sldId="269"/>
            <ac:spMk id="18" creationId="{00000000-0000-0000-0000-000000000000}"/>
          </ac:spMkLst>
        </pc:spChg>
        <pc:spChg chg="mod">
          <ac:chgData name="Nannan Yang" userId="8c3b9c4b-18b4-464d-ad2a-754aea970d34" providerId="ADAL" clId="{42A03141-E764-4934-9602-96E5E4C1DB98}" dt="2021-09-06T11:54:48.624" v="163" actId="14100"/>
          <ac:spMkLst>
            <pc:docMk/>
            <pc:sldMk cId="1287737704" sldId="269"/>
            <ac:spMk id="19" creationId="{00000000-0000-0000-0000-000000000000}"/>
          </ac:spMkLst>
        </pc:spChg>
        <pc:spChg chg="mod">
          <ac:chgData name="Nannan Yang" userId="8c3b9c4b-18b4-464d-ad2a-754aea970d34" providerId="ADAL" clId="{42A03141-E764-4934-9602-96E5E4C1DB98}" dt="2021-09-06T11:54:22.870" v="151" actId="14100"/>
          <ac:spMkLst>
            <pc:docMk/>
            <pc:sldMk cId="1287737704" sldId="269"/>
            <ac:spMk id="22" creationId="{00000000-0000-0000-0000-000000000000}"/>
          </ac:spMkLst>
        </pc:spChg>
        <pc:spChg chg="mod">
          <ac:chgData name="Nannan Yang" userId="8c3b9c4b-18b4-464d-ad2a-754aea970d34" providerId="ADAL" clId="{42A03141-E764-4934-9602-96E5E4C1DB98}" dt="2021-09-06T11:54:31.816" v="155" actId="14100"/>
          <ac:spMkLst>
            <pc:docMk/>
            <pc:sldMk cId="1287737704" sldId="269"/>
            <ac:spMk id="23" creationId="{00000000-0000-0000-0000-000000000000}"/>
          </ac:spMkLst>
        </pc:spChg>
        <pc:spChg chg="add mod">
          <ac:chgData name="Nannan Yang" userId="8c3b9c4b-18b4-464d-ad2a-754aea970d34" providerId="ADAL" clId="{42A03141-E764-4934-9602-96E5E4C1DB98}" dt="2021-09-20T06:39:17.019" v="343" actId="552"/>
          <ac:spMkLst>
            <pc:docMk/>
            <pc:sldMk cId="1287737704" sldId="269"/>
            <ac:spMk id="24" creationId="{C6F64226-3545-4307-8AE6-F7974D8C764C}"/>
          </ac:spMkLst>
        </pc:spChg>
        <pc:spChg chg="mod">
          <ac:chgData name="Nannan Yang" userId="8c3b9c4b-18b4-464d-ad2a-754aea970d34" providerId="ADAL" clId="{42A03141-E764-4934-9602-96E5E4C1DB98}" dt="2021-09-20T06:42:11.605" v="560" actId="113"/>
          <ac:spMkLst>
            <pc:docMk/>
            <pc:sldMk cId="1287737704" sldId="269"/>
            <ac:spMk id="25" creationId="{8B8165B5-E36B-480C-91D1-CAF43D00DD51}"/>
          </ac:spMkLst>
        </pc:spChg>
        <pc:spChg chg="add mod">
          <ac:chgData name="Nannan Yang" userId="8c3b9c4b-18b4-464d-ad2a-754aea970d34" providerId="ADAL" clId="{42A03141-E764-4934-9602-96E5E4C1DB98}" dt="2021-09-20T06:39:17.019" v="343" actId="552"/>
          <ac:spMkLst>
            <pc:docMk/>
            <pc:sldMk cId="1287737704" sldId="269"/>
            <ac:spMk id="26" creationId="{1B49DC62-801B-4E18-839D-DA4FD8154FF2}"/>
          </ac:spMkLst>
        </pc:spChg>
        <pc:spChg chg="add mod">
          <ac:chgData name="Nannan Yang" userId="8c3b9c4b-18b4-464d-ad2a-754aea970d34" providerId="ADAL" clId="{42A03141-E764-4934-9602-96E5E4C1DB98}" dt="2021-09-20T06:39:17.019" v="343" actId="552"/>
          <ac:spMkLst>
            <pc:docMk/>
            <pc:sldMk cId="1287737704" sldId="269"/>
            <ac:spMk id="27" creationId="{8CEC5495-7653-42AF-8CFB-5A5A9D13227B}"/>
          </ac:spMkLst>
        </pc:spChg>
        <pc:grpChg chg="mod">
          <ac:chgData name="Nannan Yang" userId="8c3b9c4b-18b4-464d-ad2a-754aea970d34" providerId="ADAL" clId="{42A03141-E764-4934-9602-96E5E4C1DB98}" dt="2021-08-13T06:17:39.652" v="60"/>
          <ac:grpSpMkLst>
            <pc:docMk/>
            <pc:sldMk cId="1287737704" sldId="269"/>
            <ac:grpSpMk id="9" creationId="{00000000-0000-0000-0000-000000000000}"/>
          </ac:grpSpMkLst>
        </pc:grpChg>
        <pc:grpChg chg="mod">
          <ac:chgData name="Nannan Yang" userId="8c3b9c4b-18b4-464d-ad2a-754aea970d34" providerId="ADAL" clId="{42A03141-E764-4934-9602-96E5E4C1DB98}" dt="2021-08-13T06:17:39.652" v="60"/>
          <ac:grpSpMkLst>
            <pc:docMk/>
            <pc:sldMk cId="1287737704" sldId="269"/>
            <ac:grpSpMk id="11" creationId="{00000000-0000-0000-0000-000000000000}"/>
          </ac:grpSpMkLst>
        </pc:grpChg>
      </pc:sldChg>
      <pc:sldChg chg="addSp modSp">
        <pc:chgData name="Nannan Yang" userId="8c3b9c4b-18b4-464d-ad2a-754aea970d34" providerId="ADAL" clId="{42A03141-E764-4934-9602-96E5E4C1DB98}" dt="2021-09-06T12:05:28.547" v="330" actId="1035"/>
        <pc:sldMkLst>
          <pc:docMk/>
          <pc:sldMk cId="2392059747" sldId="270"/>
        </pc:sldMkLst>
        <pc:spChg chg="add mod ord">
          <ac:chgData name="Nannan Yang" userId="8c3b9c4b-18b4-464d-ad2a-754aea970d34" providerId="ADAL" clId="{42A03141-E764-4934-9602-96E5E4C1DB98}" dt="2021-09-06T12:04:48.871" v="296" actId="1037"/>
          <ac:spMkLst>
            <pc:docMk/>
            <pc:sldMk cId="2392059747" sldId="270"/>
            <ac:spMk id="2" creationId="{25DA70D2-4F90-4986-88D2-224040695143}"/>
          </ac:spMkLst>
        </pc:spChg>
        <pc:spChg chg="add mod">
          <ac:chgData name="Nannan Yang" userId="8c3b9c4b-18b4-464d-ad2a-754aea970d34" providerId="ADAL" clId="{42A03141-E764-4934-9602-96E5E4C1DB98}" dt="2021-09-06T12:04:01.320" v="278" actId="1038"/>
          <ac:spMkLst>
            <pc:docMk/>
            <pc:sldMk cId="2392059747" sldId="270"/>
            <ac:spMk id="3" creationId="{A1F164C1-D0D3-4324-863D-1070976D5E9F}"/>
          </ac:spMkLst>
        </pc:spChg>
        <pc:spChg chg="add mod">
          <ac:chgData name="Nannan Yang" userId="8c3b9c4b-18b4-464d-ad2a-754aea970d34" providerId="ADAL" clId="{42A03141-E764-4934-9602-96E5E4C1DB98}" dt="2021-09-06T12:05:28.547" v="330" actId="1035"/>
          <ac:spMkLst>
            <pc:docMk/>
            <pc:sldMk cId="2392059747" sldId="270"/>
            <ac:spMk id="6" creationId="{4EA07CB2-E2C8-4C35-BA51-9E376A1ECCA0}"/>
          </ac:spMkLst>
        </pc:spChg>
        <pc:spChg chg="mod">
          <ac:chgData name="Nannan Yang" userId="8c3b9c4b-18b4-464d-ad2a-754aea970d34" providerId="ADAL" clId="{42A03141-E764-4934-9602-96E5E4C1DB98}" dt="2021-08-13T06:19:33.404" v="98" actId="1035"/>
          <ac:spMkLst>
            <pc:docMk/>
            <pc:sldMk cId="2392059747" sldId="270"/>
            <ac:spMk id="7" creationId="{00000000-0000-0000-0000-000000000000}"/>
          </ac:spMkLst>
        </pc:spChg>
        <pc:spChg chg="mod">
          <ac:chgData name="Nannan Yang" userId="8c3b9c4b-18b4-464d-ad2a-754aea970d34" providerId="ADAL" clId="{42A03141-E764-4934-9602-96E5E4C1DB98}" dt="2021-09-06T12:03:34.732" v="264" actId="58"/>
          <ac:spMkLst>
            <pc:docMk/>
            <pc:sldMk cId="2392059747" sldId="270"/>
            <ac:spMk id="8" creationId="{00000000-0000-0000-0000-000000000000}"/>
          </ac:spMkLst>
        </pc:spChg>
        <pc:spChg chg="mod">
          <ac:chgData name="Nannan Yang" userId="8c3b9c4b-18b4-464d-ad2a-754aea970d34" providerId="ADAL" clId="{42A03141-E764-4934-9602-96E5E4C1DB98}" dt="2021-09-06T11:55:04.070" v="165" actId="114"/>
          <ac:spMkLst>
            <pc:docMk/>
            <pc:sldMk cId="2392059747" sldId="270"/>
            <ac:spMk id="9" creationId="{DDF62252-4147-401F-AD51-9ED3A5DF2105}"/>
          </ac:spMkLst>
        </pc:spChg>
        <pc:grpChg chg="mod">
          <ac:chgData name="Nannan Yang" userId="8c3b9c4b-18b4-464d-ad2a-754aea970d34" providerId="ADAL" clId="{42A03141-E764-4934-9602-96E5E4C1DB98}" dt="2021-09-06T12:03:34.732" v="264" actId="58"/>
          <ac:grpSpMkLst>
            <pc:docMk/>
            <pc:sldMk cId="2392059747" sldId="270"/>
            <ac:grpSpMk id="5" creationId="{00000000-0000-0000-0000-000000000000}"/>
          </ac:grpSpMkLst>
        </pc:grpChg>
      </pc:sldChg>
      <pc:sldChg chg="del">
        <pc:chgData name="Nannan Yang" userId="8c3b9c4b-18b4-464d-ad2a-754aea970d34" providerId="ADAL" clId="{42A03141-E764-4934-9602-96E5E4C1DB98}" dt="2021-08-10T01:21:51.380" v="2" actId="2696"/>
        <pc:sldMkLst>
          <pc:docMk/>
          <pc:sldMk cId="4193192991" sldId="277"/>
        </pc:sldMkLst>
      </pc:sldChg>
      <pc:sldChg chg="del">
        <pc:chgData name="Nannan Yang" userId="8c3b9c4b-18b4-464d-ad2a-754aea970d34" providerId="ADAL" clId="{42A03141-E764-4934-9602-96E5E4C1DB98}" dt="2021-08-10T01:21:51.643" v="16" actId="2696"/>
        <pc:sldMkLst>
          <pc:docMk/>
          <pc:sldMk cId="2485764467" sldId="280"/>
        </pc:sldMkLst>
      </pc:sldChg>
      <pc:sldChg chg="del">
        <pc:chgData name="Nannan Yang" userId="8c3b9c4b-18b4-464d-ad2a-754aea970d34" providerId="ADAL" clId="{42A03141-E764-4934-9602-96E5E4C1DB98}" dt="2021-08-10T01:21:51.568" v="12" actId="2696"/>
        <pc:sldMkLst>
          <pc:docMk/>
          <pc:sldMk cId="1975742255" sldId="281"/>
        </pc:sldMkLst>
      </pc:sldChg>
      <pc:sldChg chg="del">
        <pc:chgData name="Nannan Yang" userId="8c3b9c4b-18b4-464d-ad2a-754aea970d34" providerId="ADAL" clId="{42A03141-E764-4934-9602-96E5E4C1DB98}" dt="2021-08-10T01:21:51.418" v="4" actId="2696"/>
        <pc:sldMkLst>
          <pc:docMk/>
          <pc:sldMk cId="868431158" sldId="282"/>
        </pc:sldMkLst>
      </pc:sldChg>
      <pc:sldChg chg="del">
        <pc:chgData name="Nannan Yang" userId="8c3b9c4b-18b4-464d-ad2a-754aea970d34" providerId="ADAL" clId="{42A03141-E764-4934-9602-96E5E4C1DB98}" dt="2021-08-10T01:21:51.589" v="13" actId="2696"/>
        <pc:sldMkLst>
          <pc:docMk/>
          <pc:sldMk cId="3546096453" sldId="283"/>
        </pc:sldMkLst>
      </pc:sldChg>
      <pc:sldChg chg="del">
        <pc:chgData name="Nannan Yang" userId="8c3b9c4b-18b4-464d-ad2a-754aea970d34" providerId="ADAL" clId="{42A03141-E764-4934-9602-96E5E4C1DB98}" dt="2021-08-10T01:21:52.015" v="39" actId="2696"/>
        <pc:sldMkLst>
          <pc:docMk/>
          <pc:sldMk cId="653494428" sldId="284"/>
        </pc:sldMkLst>
      </pc:sldChg>
      <pc:sldChg chg="del">
        <pc:chgData name="Nannan Yang" userId="8c3b9c4b-18b4-464d-ad2a-754aea970d34" providerId="ADAL" clId="{42A03141-E764-4934-9602-96E5E4C1DB98}" dt="2021-08-10T01:21:51.870" v="29" actId="2696"/>
        <pc:sldMkLst>
          <pc:docMk/>
          <pc:sldMk cId="2046728651" sldId="285"/>
        </pc:sldMkLst>
      </pc:sldChg>
      <pc:sldChg chg="del">
        <pc:chgData name="Nannan Yang" userId="8c3b9c4b-18b4-464d-ad2a-754aea970d34" providerId="ADAL" clId="{42A03141-E764-4934-9602-96E5E4C1DB98}" dt="2021-08-10T01:21:52.031" v="40" actId="2696"/>
        <pc:sldMkLst>
          <pc:docMk/>
          <pc:sldMk cId="1171111188" sldId="286"/>
        </pc:sldMkLst>
      </pc:sldChg>
      <pc:sldChg chg="del">
        <pc:chgData name="Nannan Yang" userId="8c3b9c4b-18b4-464d-ad2a-754aea970d34" providerId="ADAL" clId="{42A03141-E764-4934-9602-96E5E4C1DB98}" dt="2021-08-10T01:21:51.886" v="30" actId="2696"/>
        <pc:sldMkLst>
          <pc:docMk/>
          <pc:sldMk cId="782360576" sldId="287"/>
        </pc:sldMkLst>
      </pc:sldChg>
      <pc:sldChg chg="del">
        <pc:chgData name="Nannan Yang" userId="8c3b9c4b-18b4-464d-ad2a-754aea970d34" providerId="ADAL" clId="{42A03141-E764-4934-9602-96E5E4C1DB98}" dt="2021-08-10T01:21:52.057" v="42" actId="2696"/>
        <pc:sldMkLst>
          <pc:docMk/>
          <pc:sldMk cId="4025418722" sldId="288"/>
        </pc:sldMkLst>
      </pc:sldChg>
      <pc:sldChg chg="del">
        <pc:chgData name="Nannan Yang" userId="8c3b9c4b-18b4-464d-ad2a-754aea970d34" providerId="ADAL" clId="{42A03141-E764-4934-9602-96E5E4C1DB98}" dt="2021-08-10T01:21:51.915" v="32" actId="2696"/>
        <pc:sldMkLst>
          <pc:docMk/>
          <pc:sldMk cId="2671637383" sldId="289"/>
        </pc:sldMkLst>
      </pc:sldChg>
      <pc:sldChg chg="del">
        <pc:chgData name="Nannan Yang" userId="8c3b9c4b-18b4-464d-ad2a-754aea970d34" providerId="ADAL" clId="{42A03141-E764-4934-9602-96E5E4C1DB98}" dt="2021-08-10T01:21:51.929" v="33" actId="2696"/>
        <pc:sldMkLst>
          <pc:docMk/>
          <pc:sldMk cId="3028668320" sldId="292"/>
        </pc:sldMkLst>
      </pc:sldChg>
      <pc:sldChg chg="del">
        <pc:chgData name="Nannan Yang" userId="8c3b9c4b-18b4-464d-ad2a-754aea970d34" providerId="ADAL" clId="{42A03141-E764-4934-9602-96E5E4C1DB98}" dt="2021-08-10T01:21:52.072" v="43" actId="2696"/>
        <pc:sldMkLst>
          <pc:docMk/>
          <pc:sldMk cId="3637948722" sldId="293"/>
        </pc:sldMkLst>
      </pc:sldChg>
      <pc:sldChg chg="del">
        <pc:chgData name="Nannan Yang" userId="8c3b9c4b-18b4-464d-ad2a-754aea970d34" providerId="ADAL" clId="{42A03141-E764-4934-9602-96E5E4C1DB98}" dt="2021-08-10T01:21:52.103" v="45" actId="2696"/>
        <pc:sldMkLst>
          <pc:docMk/>
          <pc:sldMk cId="3987299334" sldId="294"/>
        </pc:sldMkLst>
      </pc:sldChg>
      <pc:sldChg chg="del">
        <pc:chgData name="Nannan Yang" userId="8c3b9c4b-18b4-464d-ad2a-754aea970d34" providerId="ADAL" clId="{42A03141-E764-4934-9602-96E5E4C1DB98}" dt="2021-08-10T01:21:51.956" v="35" actId="2696"/>
        <pc:sldMkLst>
          <pc:docMk/>
          <pc:sldMk cId="4110232396" sldId="295"/>
        </pc:sldMkLst>
      </pc:sldChg>
      <pc:sldChg chg="del">
        <pc:chgData name="Nannan Yang" userId="8c3b9c4b-18b4-464d-ad2a-754aea970d34" providerId="ADAL" clId="{42A03141-E764-4934-9602-96E5E4C1DB98}" dt="2021-08-10T01:21:52.115" v="46" actId="2696"/>
        <pc:sldMkLst>
          <pc:docMk/>
          <pc:sldMk cId="1783313377" sldId="296"/>
        </pc:sldMkLst>
      </pc:sldChg>
      <pc:sldChg chg="del">
        <pc:chgData name="Nannan Yang" userId="8c3b9c4b-18b4-464d-ad2a-754aea970d34" providerId="ADAL" clId="{42A03141-E764-4934-9602-96E5E4C1DB98}" dt="2021-08-10T01:21:51.970" v="36" actId="2696"/>
        <pc:sldMkLst>
          <pc:docMk/>
          <pc:sldMk cId="1662014142" sldId="297"/>
        </pc:sldMkLst>
      </pc:sldChg>
      <pc:sldChg chg="del">
        <pc:chgData name="Nannan Yang" userId="8c3b9c4b-18b4-464d-ad2a-754aea970d34" providerId="ADAL" clId="{42A03141-E764-4934-9602-96E5E4C1DB98}" dt="2021-08-10T01:21:51.474" v="7" actId="2696"/>
        <pc:sldMkLst>
          <pc:docMk/>
          <pc:sldMk cId="1250120804" sldId="302"/>
        </pc:sldMkLst>
      </pc:sldChg>
      <pc:sldChg chg="del">
        <pc:chgData name="Nannan Yang" userId="8c3b9c4b-18b4-464d-ad2a-754aea970d34" providerId="ADAL" clId="{42A03141-E764-4934-9602-96E5E4C1DB98}" dt="2021-08-10T01:21:52.129" v="47" actId="2696"/>
        <pc:sldMkLst>
          <pc:docMk/>
          <pc:sldMk cId="1706742483" sldId="304"/>
        </pc:sldMkLst>
      </pc:sldChg>
      <pc:sldChg chg="del">
        <pc:chgData name="Nannan Yang" userId="8c3b9c4b-18b4-464d-ad2a-754aea970d34" providerId="ADAL" clId="{42A03141-E764-4934-9602-96E5E4C1DB98}" dt="2021-08-10T01:21:51.395" v="3" actId="2696"/>
        <pc:sldMkLst>
          <pc:docMk/>
          <pc:sldMk cId="1995577405" sldId="306"/>
        </pc:sldMkLst>
      </pc:sldChg>
      <pc:sldChg chg="del">
        <pc:chgData name="Nannan Yang" userId="8c3b9c4b-18b4-464d-ad2a-754aea970d34" providerId="ADAL" clId="{42A03141-E764-4934-9602-96E5E4C1DB98}" dt="2021-08-10T01:21:51.511" v="9" actId="2696"/>
        <pc:sldMkLst>
          <pc:docMk/>
          <pc:sldMk cId="2027623285" sldId="307"/>
        </pc:sldMkLst>
      </pc:sldChg>
      <pc:sldChg chg="del">
        <pc:chgData name="Nannan Yang" userId="8c3b9c4b-18b4-464d-ad2a-754aea970d34" providerId="ADAL" clId="{42A03141-E764-4934-9602-96E5E4C1DB98}" dt="2021-08-10T01:21:51.665" v="17" actId="2696"/>
        <pc:sldMkLst>
          <pc:docMk/>
          <pc:sldMk cId="2468973114" sldId="308"/>
        </pc:sldMkLst>
      </pc:sldChg>
      <pc:sldChg chg="del">
        <pc:chgData name="Nannan Yang" userId="8c3b9c4b-18b4-464d-ad2a-754aea970d34" providerId="ADAL" clId="{42A03141-E764-4934-9602-96E5E4C1DB98}" dt="2021-08-10T01:21:51.624" v="15" actId="2696"/>
        <pc:sldMkLst>
          <pc:docMk/>
          <pc:sldMk cId="2221261326" sldId="309"/>
        </pc:sldMkLst>
      </pc:sldChg>
      <pc:sldChg chg="del">
        <pc:chgData name="Nannan Yang" userId="8c3b9c4b-18b4-464d-ad2a-754aea970d34" providerId="ADAL" clId="{42A03141-E764-4934-9602-96E5E4C1DB98}" dt="2021-08-10T01:21:51.458" v="6" actId="2696"/>
        <pc:sldMkLst>
          <pc:docMk/>
          <pc:sldMk cId="914812490" sldId="310"/>
        </pc:sldMkLst>
      </pc:sldChg>
      <pc:sldChg chg="del">
        <pc:chgData name="Nannan Yang" userId="8c3b9c4b-18b4-464d-ad2a-754aea970d34" providerId="ADAL" clId="{42A03141-E764-4934-9602-96E5E4C1DB98}" dt="2021-08-10T01:21:51.607" v="14" actId="2696"/>
        <pc:sldMkLst>
          <pc:docMk/>
          <pc:sldMk cId="210662903" sldId="311"/>
        </pc:sldMkLst>
      </pc:sldChg>
      <pc:sldChg chg="del">
        <pc:chgData name="Nannan Yang" userId="8c3b9c4b-18b4-464d-ad2a-754aea970d34" providerId="ADAL" clId="{42A03141-E764-4934-9602-96E5E4C1DB98}" dt="2021-08-10T01:21:51.738" v="21" actId="2696"/>
        <pc:sldMkLst>
          <pc:docMk/>
          <pc:sldMk cId="773315593" sldId="312"/>
        </pc:sldMkLst>
      </pc:sldChg>
      <pc:sldChg chg="del">
        <pc:chgData name="Nannan Yang" userId="8c3b9c4b-18b4-464d-ad2a-754aea970d34" providerId="ADAL" clId="{42A03141-E764-4934-9602-96E5E4C1DB98}" dt="2021-08-10T01:21:51.899" v="31" actId="2696"/>
        <pc:sldMkLst>
          <pc:docMk/>
          <pc:sldMk cId="2051802472" sldId="313"/>
        </pc:sldMkLst>
      </pc:sldChg>
      <pc:sldChg chg="del">
        <pc:chgData name="Nannan Yang" userId="8c3b9c4b-18b4-464d-ad2a-754aea970d34" providerId="ADAL" clId="{42A03141-E764-4934-9602-96E5E4C1DB98}" dt="2021-08-10T01:21:52.044" v="41" actId="2696"/>
        <pc:sldMkLst>
          <pc:docMk/>
          <pc:sldMk cId="1272027311" sldId="314"/>
        </pc:sldMkLst>
      </pc:sldChg>
      <pc:sldChg chg="del">
        <pc:chgData name="Nannan Yang" userId="8c3b9c4b-18b4-464d-ad2a-754aea970d34" providerId="ADAL" clId="{42A03141-E764-4934-9602-96E5E4C1DB98}" dt="2021-08-10T01:21:51.788" v="24" actId="2696"/>
        <pc:sldMkLst>
          <pc:docMk/>
          <pc:sldMk cId="906913670" sldId="315"/>
        </pc:sldMkLst>
      </pc:sldChg>
      <pc:sldChg chg="del">
        <pc:chgData name="Nannan Yang" userId="8c3b9c4b-18b4-464d-ad2a-754aea970d34" providerId="ADAL" clId="{42A03141-E764-4934-9602-96E5E4C1DB98}" dt="2021-08-10T01:21:51.942" v="34" actId="2696"/>
        <pc:sldMkLst>
          <pc:docMk/>
          <pc:sldMk cId="1923963570" sldId="316"/>
        </pc:sldMkLst>
      </pc:sldChg>
      <pc:sldChg chg="del">
        <pc:chgData name="Nannan Yang" userId="8c3b9c4b-18b4-464d-ad2a-754aea970d34" providerId="ADAL" clId="{42A03141-E764-4934-9602-96E5E4C1DB98}" dt="2021-08-10T01:21:52.088" v="44" actId="2696"/>
        <pc:sldMkLst>
          <pc:docMk/>
          <pc:sldMk cId="561580848" sldId="317"/>
        </pc:sldMkLst>
      </pc:sldChg>
      <pc:sldChg chg="del">
        <pc:chgData name="Nannan Yang" userId="8c3b9c4b-18b4-464d-ad2a-754aea970d34" providerId="ADAL" clId="{42A03141-E764-4934-9602-96E5E4C1DB98}" dt="2021-08-10T01:21:51.835" v="27" actId="2696"/>
        <pc:sldMkLst>
          <pc:docMk/>
          <pc:sldMk cId="182479015" sldId="318"/>
        </pc:sldMkLst>
      </pc:sldChg>
      <pc:sldChg chg="del">
        <pc:chgData name="Nannan Yang" userId="8c3b9c4b-18b4-464d-ad2a-754aea970d34" providerId="ADAL" clId="{42A03141-E764-4934-9602-96E5E4C1DB98}" dt="2021-08-10T01:21:51.985" v="37" actId="2696"/>
        <pc:sldMkLst>
          <pc:docMk/>
          <pc:sldMk cId="3629369797" sldId="319"/>
        </pc:sldMkLst>
      </pc:sldChg>
      <pc:sldChg chg="del">
        <pc:chgData name="Nannan Yang" userId="8c3b9c4b-18b4-464d-ad2a-754aea970d34" providerId="ADAL" clId="{42A03141-E764-4934-9602-96E5E4C1DB98}" dt="2021-08-10T01:21:51.683" v="18" actId="2696"/>
        <pc:sldMkLst>
          <pc:docMk/>
          <pc:sldMk cId="552575901" sldId="320"/>
        </pc:sldMkLst>
      </pc:sldChg>
      <pc:sldChg chg="del">
        <pc:chgData name="Nannan Yang" userId="8c3b9c4b-18b4-464d-ad2a-754aea970d34" providerId="ADAL" clId="{42A03141-E764-4934-9602-96E5E4C1DB98}" dt="2021-08-10T01:21:51.531" v="10" actId="2696"/>
        <pc:sldMkLst>
          <pc:docMk/>
          <pc:sldMk cId="443958425" sldId="321"/>
        </pc:sldMkLst>
      </pc:sldChg>
      <pc:sldChg chg="del">
        <pc:chgData name="Nannan Yang" userId="8c3b9c4b-18b4-464d-ad2a-754aea970d34" providerId="ADAL" clId="{42A03141-E764-4934-9602-96E5E4C1DB98}" dt="2021-08-10T01:21:51.853" v="28" actId="2696"/>
        <pc:sldMkLst>
          <pc:docMk/>
          <pc:sldMk cId="2833439641" sldId="322"/>
        </pc:sldMkLst>
      </pc:sldChg>
      <pc:sldChg chg="del">
        <pc:chgData name="Nannan Yang" userId="8c3b9c4b-18b4-464d-ad2a-754aea970d34" providerId="ADAL" clId="{42A03141-E764-4934-9602-96E5E4C1DB98}" dt="2021-08-10T01:21:52" v="38" actId="2696"/>
        <pc:sldMkLst>
          <pc:docMk/>
          <pc:sldMk cId="1815461557" sldId="323"/>
        </pc:sldMkLst>
      </pc:sldChg>
      <pc:sldChg chg="del">
        <pc:chgData name="Nannan Yang" userId="8c3b9c4b-18b4-464d-ad2a-754aea970d34" providerId="ADAL" clId="{42A03141-E764-4934-9602-96E5E4C1DB98}" dt="2021-08-10T01:21:52.139" v="48" actId="2696"/>
        <pc:sldMkLst>
          <pc:docMk/>
          <pc:sldMk cId="2556893298" sldId="324"/>
        </pc:sldMkLst>
      </pc:sldChg>
      <pc:sldChg chg="del">
        <pc:chgData name="Nannan Yang" userId="8c3b9c4b-18b4-464d-ad2a-754aea970d34" providerId="ADAL" clId="{42A03141-E764-4934-9602-96E5E4C1DB98}" dt="2021-08-13T06:16:21.643" v="55" actId="2696"/>
        <pc:sldMkLst>
          <pc:docMk/>
          <pc:sldMk cId="2259946007" sldId="335"/>
        </pc:sldMkLst>
      </pc:sldChg>
      <pc:sldChg chg="del">
        <pc:chgData name="Nannan Yang" userId="8c3b9c4b-18b4-464d-ad2a-754aea970d34" providerId="ADAL" clId="{42A03141-E764-4934-9602-96E5E4C1DB98}" dt="2021-08-13T06:16:29.111" v="56" actId="2696"/>
        <pc:sldMkLst>
          <pc:docMk/>
          <pc:sldMk cId="1731569355" sldId="343"/>
        </pc:sldMkLst>
      </pc:sldChg>
      <pc:sldChg chg="del">
        <pc:chgData name="Nannan Yang" userId="8c3b9c4b-18b4-464d-ad2a-754aea970d34" providerId="ADAL" clId="{42A03141-E764-4934-9602-96E5E4C1DB98}" dt="2021-08-13T06:16:17.554" v="54" actId="2696"/>
        <pc:sldMkLst>
          <pc:docMk/>
          <pc:sldMk cId="623538767" sldId="344"/>
        </pc:sldMkLst>
      </pc:sldChg>
      <pc:sldChg chg="del">
        <pc:chgData name="Nannan Yang" userId="8c3b9c4b-18b4-464d-ad2a-754aea970d34" providerId="ADAL" clId="{42A03141-E764-4934-9602-96E5E4C1DB98}" dt="2021-08-13T06:16:49.109" v="59" actId="2696"/>
        <pc:sldMkLst>
          <pc:docMk/>
          <pc:sldMk cId="1904901096" sldId="348"/>
        </pc:sldMkLst>
      </pc:sldChg>
      <pc:sldChg chg="del">
        <pc:chgData name="Nannan Yang" userId="8c3b9c4b-18b4-464d-ad2a-754aea970d34" providerId="ADAL" clId="{42A03141-E764-4934-9602-96E5E4C1DB98}" dt="2021-08-13T06:16:44.564" v="57" actId="2696"/>
        <pc:sldMkLst>
          <pc:docMk/>
          <pc:sldMk cId="1841577162" sldId="355"/>
        </pc:sldMkLst>
      </pc:sldChg>
      <pc:sldChg chg="addSp delSp modSp addCm modCm">
        <pc:chgData name="Nannan Yang" userId="8c3b9c4b-18b4-464d-ad2a-754aea970d34" providerId="ADAL" clId="{42A03141-E764-4934-9602-96E5E4C1DB98}" dt="2021-09-06T12:00:10.203" v="214" actId="1036"/>
        <pc:sldMkLst>
          <pc:docMk/>
          <pc:sldMk cId="3641300011" sldId="357"/>
        </pc:sldMkLst>
        <pc:spChg chg="add del mod">
          <ac:chgData name="Nannan Yang" userId="8c3b9c4b-18b4-464d-ad2a-754aea970d34" providerId="ADAL" clId="{42A03141-E764-4934-9602-96E5E4C1DB98}" dt="2021-09-06T11:56:49.187" v="186" actId="478"/>
          <ac:spMkLst>
            <pc:docMk/>
            <pc:sldMk cId="3641300011" sldId="357"/>
            <ac:spMk id="2" creationId="{2199670F-8DD8-4D3F-8B58-859484F58703}"/>
          </ac:spMkLst>
        </pc:spChg>
        <pc:spChg chg="add mod">
          <ac:chgData name="Nannan Yang" userId="8c3b9c4b-18b4-464d-ad2a-754aea970d34" providerId="ADAL" clId="{42A03141-E764-4934-9602-96E5E4C1DB98}" dt="2021-09-06T12:00:10.203" v="214" actId="1036"/>
          <ac:spMkLst>
            <pc:docMk/>
            <pc:sldMk cId="3641300011" sldId="357"/>
            <ac:spMk id="3" creationId="{01EEAC91-45AB-426C-8385-8B64313D74FB}"/>
          </ac:spMkLst>
        </pc:spChg>
        <pc:spChg chg="add mod">
          <ac:chgData name="Nannan Yang" userId="8c3b9c4b-18b4-464d-ad2a-754aea970d34" providerId="ADAL" clId="{42A03141-E764-4934-9602-96E5E4C1DB98}" dt="2021-09-06T12:00:10.203" v="214" actId="1036"/>
          <ac:spMkLst>
            <pc:docMk/>
            <pc:sldMk cId="3641300011" sldId="357"/>
            <ac:spMk id="6" creationId="{6899AF82-63ED-4C01-97BE-E7CD992597C2}"/>
          </ac:spMkLst>
        </pc:spChg>
        <pc:spChg chg="mod">
          <ac:chgData name="Nannan Yang" userId="8c3b9c4b-18b4-464d-ad2a-754aea970d34" providerId="ADAL" clId="{42A03141-E764-4934-9602-96E5E4C1DB98}" dt="2021-08-13T06:40:30.906" v="125" actId="20577"/>
          <ac:spMkLst>
            <pc:docMk/>
            <pc:sldMk cId="3641300011" sldId="357"/>
            <ac:spMk id="30" creationId="{0375105A-91A1-4A78-A0C8-A96DF352DB66}"/>
          </ac:spMkLst>
        </pc:spChg>
        <pc:picChg chg="add del mod">
          <ac:chgData name="Nannan Yang" userId="8c3b9c4b-18b4-464d-ad2a-754aea970d34" providerId="ADAL" clId="{42A03141-E764-4934-9602-96E5E4C1DB98}" dt="2021-08-23T00:28:43.173" v="145" actId="478"/>
          <ac:picMkLst>
            <pc:docMk/>
            <pc:sldMk cId="3641300011" sldId="357"/>
            <ac:picMk id="4" creationId="{72F93101-017D-4AE0-9432-270FBE9CE022}"/>
          </ac:picMkLst>
        </pc:picChg>
        <pc:picChg chg="del">
          <ac:chgData name="Nannan Yang" userId="8c3b9c4b-18b4-464d-ad2a-754aea970d34" providerId="ADAL" clId="{42A03141-E764-4934-9602-96E5E4C1DB98}" dt="2021-08-13T06:15:27.132" v="51" actId="478"/>
          <ac:picMkLst>
            <pc:docMk/>
            <pc:sldMk cId="3641300011" sldId="357"/>
            <ac:picMk id="5" creationId="{190EE9A2-AD59-4AC9-94A8-93BABF279A42}"/>
          </ac:picMkLst>
        </pc:picChg>
        <pc:picChg chg="add del mod modCrop">
          <ac:chgData name="Nannan Yang" userId="8c3b9c4b-18b4-464d-ad2a-754aea970d34" providerId="ADAL" clId="{42A03141-E764-4934-9602-96E5E4C1DB98}" dt="2021-09-06T11:59:04.462" v="189" actId="478"/>
          <ac:picMkLst>
            <pc:docMk/>
            <pc:sldMk cId="3641300011" sldId="357"/>
            <ac:picMk id="5" creationId="{B60D3816-6E90-49E0-9C3B-B3C8A2F98D38}"/>
          </ac:picMkLst>
        </pc:picChg>
      </pc:sldChg>
      <pc:sldChg chg="del">
        <pc:chgData name="Nannan Yang" userId="8c3b9c4b-18b4-464d-ad2a-754aea970d34" providerId="ADAL" clId="{42A03141-E764-4934-9602-96E5E4C1DB98}" dt="2021-08-10T01:23:21.884" v="50" actId="2696"/>
        <pc:sldMkLst>
          <pc:docMk/>
          <pc:sldMk cId="3420684637" sldId="359"/>
        </pc:sldMkLst>
      </pc:sldChg>
      <pc:sldChg chg="del">
        <pc:chgData name="Nannan Yang" userId="8c3b9c4b-18b4-464d-ad2a-754aea970d34" providerId="ADAL" clId="{42A03141-E764-4934-9602-96E5E4C1DB98}" dt="2021-08-10T01:22:04.597" v="49" actId="2696"/>
        <pc:sldMkLst>
          <pc:docMk/>
          <pc:sldMk cId="35834858" sldId="361"/>
        </pc:sldMkLst>
      </pc:sldChg>
      <pc:sldChg chg="del">
        <pc:chgData name="Nannan Yang" userId="8c3b9c4b-18b4-464d-ad2a-754aea970d34" providerId="ADAL" clId="{42A03141-E764-4934-9602-96E5E4C1DB98}" dt="2021-08-13T06:16:46.967" v="58" actId="2696"/>
        <pc:sldMkLst>
          <pc:docMk/>
          <pc:sldMk cId="1699889881" sldId="362"/>
        </pc:sldMkLst>
      </pc:sldChg>
    </pc:docChg>
  </pc:docChgLst>
  <pc:docChgLst>
    <pc:chgData name="Nannan Yang" userId="8c3b9c4b-18b4-464d-ad2a-754aea970d34" providerId="ADAL" clId="{83F0A2AA-337F-4EDA-A85A-13083B4D8B6D}"/>
    <pc:docChg chg="custSel addSld modSld">
      <pc:chgData name="Nannan Yang" userId="8c3b9c4b-18b4-464d-ad2a-754aea970d34" providerId="ADAL" clId="{83F0A2AA-337F-4EDA-A85A-13083B4D8B6D}" dt="2022-06-03T00:28:40.926" v="109" actId="1592"/>
      <pc:docMkLst>
        <pc:docMk/>
      </pc:docMkLst>
      <pc:sldChg chg="delCm">
        <pc:chgData name="Nannan Yang" userId="8c3b9c4b-18b4-464d-ad2a-754aea970d34" providerId="ADAL" clId="{83F0A2AA-337F-4EDA-A85A-13083B4D8B6D}" dt="2022-06-03T00:28:40.926" v="109" actId="1592"/>
        <pc:sldMkLst>
          <pc:docMk/>
          <pc:sldMk cId="3641300011" sldId="357"/>
        </pc:sldMkLst>
      </pc:sldChg>
      <pc:sldChg chg="addSp delSp modSp new mod">
        <pc:chgData name="Nannan Yang" userId="8c3b9c4b-18b4-464d-ad2a-754aea970d34" providerId="ADAL" clId="{83F0A2AA-337F-4EDA-A85A-13083B4D8B6D}" dt="2022-06-01T06:34:34.627" v="108" actId="20577"/>
        <pc:sldMkLst>
          <pc:docMk/>
          <pc:sldMk cId="1071950960" sldId="358"/>
        </pc:sldMkLst>
        <pc:spChg chg="del">
          <ac:chgData name="Nannan Yang" userId="8c3b9c4b-18b4-464d-ad2a-754aea970d34" providerId="ADAL" clId="{83F0A2AA-337F-4EDA-A85A-13083B4D8B6D}" dt="2022-06-01T02:03:30.139" v="2" actId="478"/>
          <ac:spMkLst>
            <pc:docMk/>
            <pc:sldMk cId="1071950960" sldId="358"/>
            <ac:spMk id="2" creationId="{A2B81459-84AA-4414-8841-4583DD856B2F}"/>
          </ac:spMkLst>
        </pc:spChg>
        <pc:spChg chg="del">
          <ac:chgData name="Nannan Yang" userId="8c3b9c4b-18b4-464d-ad2a-754aea970d34" providerId="ADAL" clId="{83F0A2AA-337F-4EDA-A85A-13083B4D8B6D}" dt="2022-06-01T02:03:28.911" v="1" actId="478"/>
          <ac:spMkLst>
            <pc:docMk/>
            <pc:sldMk cId="1071950960" sldId="358"/>
            <ac:spMk id="3" creationId="{E21756E7-2278-492A-A775-42F081000143}"/>
          </ac:spMkLst>
        </pc:spChg>
        <pc:spChg chg="add mod">
          <ac:chgData name="Nannan Yang" userId="8c3b9c4b-18b4-464d-ad2a-754aea970d34" providerId="ADAL" clId="{83F0A2AA-337F-4EDA-A85A-13083B4D8B6D}" dt="2022-06-01T02:25:19.265" v="39" actId="20577"/>
          <ac:spMkLst>
            <pc:docMk/>
            <pc:sldMk cId="1071950960" sldId="358"/>
            <ac:spMk id="15" creationId="{D49FE0D6-205E-4C94-84B3-F7296139D4BB}"/>
          </ac:spMkLst>
        </pc:spChg>
        <pc:spChg chg="add mod">
          <ac:chgData name="Nannan Yang" userId="8c3b9c4b-18b4-464d-ad2a-754aea970d34" providerId="ADAL" clId="{83F0A2AA-337F-4EDA-A85A-13083B4D8B6D}" dt="2022-06-01T02:25:31.163" v="43" actId="20577"/>
          <ac:spMkLst>
            <pc:docMk/>
            <pc:sldMk cId="1071950960" sldId="358"/>
            <ac:spMk id="16" creationId="{2BE36AEC-836E-4A03-941A-C382FEF0754D}"/>
          </ac:spMkLst>
        </pc:spChg>
        <pc:spChg chg="add mod">
          <ac:chgData name="Nannan Yang" userId="8c3b9c4b-18b4-464d-ad2a-754aea970d34" providerId="ADAL" clId="{83F0A2AA-337F-4EDA-A85A-13083B4D8B6D}" dt="2022-06-01T06:33:43.963" v="94" actId="14100"/>
          <ac:spMkLst>
            <pc:docMk/>
            <pc:sldMk cId="1071950960" sldId="358"/>
            <ac:spMk id="17" creationId="{BB857060-15BE-496F-8438-6DBD88121E17}"/>
          </ac:spMkLst>
        </pc:spChg>
        <pc:spChg chg="add mod">
          <ac:chgData name="Nannan Yang" userId="8c3b9c4b-18b4-464d-ad2a-754aea970d34" providerId="ADAL" clId="{83F0A2AA-337F-4EDA-A85A-13083B4D8B6D}" dt="2022-06-01T06:33:52.265" v="102" actId="14100"/>
          <ac:spMkLst>
            <pc:docMk/>
            <pc:sldMk cId="1071950960" sldId="358"/>
            <ac:spMk id="18" creationId="{77ED66BF-37EA-4A91-A617-668D532D8619}"/>
          </ac:spMkLst>
        </pc:spChg>
        <pc:spChg chg="add mod">
          <ac:chgData name="Nannan Yang" userId="8c3b9c4b-18b4-464d-ad2a-754aea970d34" providerId="ADAL" clId="{83F0A2AA-337F-4EDA-A85A-13083B4D8B6D}" dt="2022-06-01T06:34:34.627" v="108" actId="20577"/>
          <ac:spMkLst>
            <pc:docMk/>
            <pc:sldMk cId="1071950960" sldId="358"/>
            <ac:spMk id="19" creationId="{54698D39-3961-4848-B99C-1A63AB6DC9EF}"/>
          </ac:spMkLst>
        </pc:spChg>
        <pc:picChg chg="add mod modCrop">
          <ac:chgData name="Nannan Yang" userId="8c3b9c4b-18b4-464d-ad2a-754aea970d34" providerId="ADAL" clId="{83F0A2AA-337F-4EDA-A85A-13083B4D8B6D}" dt="2022-06-01T02:23:47.736" v="26" actId="1076"/>
          <ac:picMkLst>
            <pc:docMk/>
            <pc:sldMk cId="1071950960" sldId="358"/>
            <ac:picMk id="4" creationId="{41A9195B-4A7F-4AB2-B0B5-64F665A398CC}"/>
          </ac:picMkLst>
        </pc:picChg>
        <pc:picChg chg="add mod">
          <ac:chgData name="Nannan Yang" userId="8c3b9c4b-18b4-464d-ad2a-754aea970d34" providerId="ADAL" clId="{83F0A2AA-337F-4EDA-A85A-13083B4D8B6D}" dt="2022-06-01T02:24:50.529" v="34" actId="553"/>
          <ac:picMkLst>
            <pc:docMk/>
            <pc:sldMk cId="1071950960" sldId="358"/>
            <ac:picMk id="6" creationId="{5488DA60-A483-4573-A71F-4909980B818D}"/>
          </ac:picMkLst>
        </pc:picChg>
        <pc:picChg chg="add mod modCrop">
          <ac:chgData name="Nannan Yang" userId="8c3b9c4b-18b4-464d-ad2a-754aea970d34" providerId="ADAL" clId="{83F0A2AA-337F-4EDA-A85A-13083B4D8B6D}" dt="2022-06-01T02:23:47.736" v="26" actId="1076"/>
          <ac:picMkLst>
            <pc:docMk/>
            <pc:sldMk cId="1071950960" sldId="358"/>
            <ac:picMk id="7" creationId="{BA7E4E1B-C48A-42DB-86EA-4CE78B2BCBDC}"/>
          </ac:picMkLst>
        </pc:picChg>
        <pc:picChg chg="add mod">
          <ac:chgData name="Nannan Yang" userId="8c3b9c4b-18b4-464d-ad2a-754aea970d34" providerId="ADAL" clId="{83F0A2AA-337F-4EDA-A85A-13083B4D8B6D}" dt="2022-06-01T02:24:50.529" v="34" actId="553"/>
          <ac:picMkLst>
            <pc:docMk/>
            <pc:sldMk cId="1071950960" sldId="358"/>
            <ac:picMk id="9" creationId="{CC10D5BE-4580-45AC-ABE3-9CB1F47DA6D1}"/>
          </ac:picMkLst>
        </pc:picChg>
        <pc:picChg chg="add mod">
          <ac:chgData name="Nannan Yang" userId="8c3b9c4b-18b4-464d-ad2a-754aea970d34" providerId="ADAL" clId="{83F0A2AA-337F-4EDA-A85A-13083B4D8B6D}" dt="2022-06-01T02:24:50.529" v="34" actId="553"/>
          <ac:picMkLst>
            <pc:docMk/>
            <pc:sldMk cId="1071950960" sldId="358"/>
            <ac:picMk id="10" creationId="{BD14F8E6-144F-4551-BBD6-F290D588309C}"/>
          </ac:picMkLst>
        </pc:picChg>
        <pc:picChg chg="add mod modCrop">
          <ac:chgData name="Nannan Yang" userId="8c3b9c4b-18b4-464d-ad2a-754aea970d34" providerId="ADAL" clId="{83F0A2AA-337F-4EDA-A85A-13083B4D8B6D}" dt="2022-06-01T02:23:32.646" v="24" actId="732"/>
          <ac:picMkLst>
            <pc:docMk/>
            <pc:sldMk cId="1071950960" sldId="358"/>
            <ac:picMk id="11" creationId="{BC48BDB1-A4EE-408E-8C5F-EC17492C36BF}"/>
          </ac:picMkLst>
        </pc:picChg>
        <pc:picChg chg="add mod modCrop">
          <ac:chgData name="Nannan Yang" userId="8c3b9c4b-18b4-464d-ad2a-754aea970d34" providerId="ADAL" clId="{83F0A2AA-337F-4EDA-A85A-13083B4D8B6D}" dt="2022-06-01T02:24:07.158" v="29" actId="732"/>
          <ac:picMkLst>
            <pc:docMk/>
            <pc:sldMk cId="1071950960" sldId="358"/>
            <ac:picMk id="12" creationId="{32C47286-3AD7-4CE8-9223-6CE7EAB47D0C}"/>
          </ac:picMkLst>
        </pc:picChg>
        <pc:picChg chg="add mod">
          <ac:chgData name="Nannan Yang" userId="8c3b9c4b-18b4-464d-ad2a-754aea970d34" providerId="ADAL" clId="{83F0A2AA-337F-4EDA-A85A-13083B4D8B6D}" dt="2022-06-01T02:24:50.529" v="34" actId="553"/>
          <ac:picMkLst>
            <pc:docMk/>
            <pc:sldMk cId="1071950960" sldId="358"/>
            <ac:picMk id="14" creationId="{E0BAC06A-BA6A-4EAF-8284-61DE17CFEBA7}"/>
          </ac:picMkLst>
        </pc:picChg>
      </pc:sldChg>
    </pc:docChg>
  </pc:docChgLst>
  <pc:docChgLst>
    <pc:chgData name="Nannan Yang" userId="8c3b9c4b-18b4-464d-ad2a-754aea970d34" providerId="ADAL" clId="{47F0A9E1-6C34-4CB5-B6ED-EC275C73BF7D}"/>
    <pc:docChg chg="modSld">
      <pc:chgData name="Nannan Yang" userId="8c3b9c4b-18b4-464d-ad2a-754aea970d34" providerId="ADAL" clId="{47F0A9E1-6C34-4CB5-B6ED-EC275C73BF7D}" dt="2021-11-11T23:05:10.156" v="33" actId="20577"/>
      <pc:docMkLst>
        <pc:docMk/>
      </pc:docMkLst>
      <pc:sldChg chg="modSp">
        <pc:chgData name="Nannan Yang" userId="8c3b9c4b-18b4-464d-ad2a-754aea970d34" providerId="ADAL" clId="{47F0A9E1-6C34-4CB5-B6ED-EC275C73BF7D}" dt="2021-11-11T23:05:10.156" v="33" actId="20577"/>
        <pc:sldMkLst>
          <pc:docMk/>
          <pc:sldMk cId="1287737704" sldId="269"/>
        </pc:sldMkLst>
        <pc:spChg chg="mod">
          <ac:chgData name="Nannan Yang" userId="8c3b9c4b-18b4-464d-ad2a-754aea970d34" providerId="ADAL" clId="{47F0A9E1-6C34-4CB5-B6ED-EC275C73BF7D}" dt="2021-11-11T23:05:10.156" v="33" actId="20577"/>
          <ac:spMkLst>
            <pc:docMk/>
            <pc:sldMk cId="1287737704" sldId="269"/>
            <ac:spMk id="25" creationId="{8B8165B5-E36B-480C-91D1-CAF43D00DD51}"/>
          </ac:spMkLst>
        </pc:spChg>
      </pc:sldChg>
      <pc:sldChg chg="modSp">
        <pc:chgData name="Nannan Yang" userId="8c3b9c4b-18b4-464d-ad2a-754aea970d34" providerId="ADAL" clId="{47F0A9E1-6C34-4CB5-B6ED-EC275C73BF7D}" dt="2021-11-11T23:04:04.634" v="30" actId="113"/>
        <pc:sldMkLst>
          <pc:docMk/>
          <pc:sldMk cId="2392059747" sldId="270"/>
        </pc:sldMkLst>
        <pc:spChg chg="mod">
          <ac:chgData name="Nannan Yang" userId="8c3b9c4b-18b4-464d-ad2a-754aea970d34" providerId="ADAL" clId="{47F0A9E1-6C34-4CB5-B6ED-EC275C73BF7D}" dt="2021-11-11T23:04:00.629" v="29" actId="113"/>
          <ac:spMkLst>
            <pc:docMk/>
            <pc:sldMk cId="2392059747" sldId="270"/>
            <ac:spMk id="7" creationId="{00000000-0000-0000-0000-000000000000}"/>
          </ac:spMkLst>
        </pc:spChg>
        <pc:spChg chg="mod">
          <ac:chgData name="Nannan Yang" userId="8c3b9c4b-18b4-464d-ad2a-754aea970d34" providerId="ADAL" clId="{47F0A9E1-6C34-4CB5-B6ED-EC275C73BF7D}" dt="2021-11-11T23:04:04.634" v="30" actId="113"/>
          <ac:spMkLst>
            <pc:docMk/>
            <pc:sldMk cId="2392059747" sldId="270"/>
            <ac:spMk id="8" creationId="{00000000-0000-0000-0000-000000000000}"/>
          </ac:spMkLst>
        </pc:spChg>
      </pc:sldChg>
      <pc:sldChg chg="modSp">
        <pc:chgData name="Nannan Yang" userId="8c3b9c4b-18b4-464d-ad2a-754aea970d34" providerId="ADAL" clId="{47F0A9E1-6C34-4CB5-B6ED-EC275C73BF7D}" dt="2021-11-11T23:02:58.173" v="18" actId="20577"/>
        <pc:sldMkLst>
          <pc:docMk/>
          <pc:sldMk cId="3641300011" sldId="357"/>
        </pc:sldMkLst>
        <pc:spChg chg="mod">
          <ac:chgData name="Nannan Yang" userId="8c3b9c4b-18b4-464d-ad2a-754aea970d34" providerId="ADAL" clId="{47F0A9E1-6C34-4CB5-B6ED-EC275C73BF7D}" dt="2021-11-11T23:02:58.173" v="18" actId="20577"/>
          <ac:spMkLst>
            <pc:docMk/>
            <pc:sldMk cId="3641300011" sldId="357"/>
            <ac:spMk id="30" creationId="{0375105A-91A1-4A78-A0C8-A96DF352DB66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A5F971-BB2B-4581-B552-B402B7FF7304}" type="datetimeFigureOut">
              <a:rPr lang="en-AU" smtClean="0"/>
              <a:t>3/06/2022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58988" y="739775"/>
            <a:ext cx="2617787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15373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1944401-54EF-477D-AA82-0264E73F8A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247509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944401-54EF-477D-AA82-0264E73F8AF1}" type="slidenum">
              <a:rPr lang="en-AU" smtClean="0"/>
              <a:t>2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4679612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058988" y="739775"/>
            <a:ext cx="2617787" cy="3700463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944401-54EF-477D-AA82-0264E73F8AF1}" type="slidenum">
              <a:rPr lang="en-AU" smtClean="0"/>
              <a:t>3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472441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3321393"/>
            <a:ext cx="6425724" cy="229181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33952" y="6058694"/>
            <a:ext cx="5291772" cy="273235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3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4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5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6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68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80765" y="428170"/>
            <a:ext cx="1700927" cy="912269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7984" y="428170"/>
            <a:ext cx="4976786" cy="912269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7162" y="6870482"/>
            <a:ext cx="6425724" cy="2123512"/>
          </a:xfrm>
        </p:spPr>
        <p:txBody>
          <a:bodyPr anchor="t"/>
          <a:lstStyle>
            <a:lvl1pPr algn="l">
              <a:defRPr sz="3999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7162" y="4531648"/>
            <a:ext cx="6425724" cy="2338833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0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32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43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5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65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76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686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7983" y="2494757"/>
            <a:ext cx="3338857" cy="7056103"/>
          </a:xfrm>
        </p:spPr>
        <p:txBody>
          <a:bodyPr/>
          <a:lstStyle>
            <a:lvl1pPr>
              <a:defRPr sz="2799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42835" y="2494757"/>
            <a:ext cx="3338857" cy="7056103"/>
          </a:xfrm>
        </p:spPr>
        <p:txBody>
          <a:bodyPr/>
          <a:lstStyle>
            <a:lvl1pPr>
              <a:defRPr sz="2799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7984" y="2393284"/>
            <a:ext cx="3340169" cy="9974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09" indent="0">
              <a:buNone/>
              <a:defRPr sz="2000" b="1"/>
            </a:lvl2pPr>
            <a:lvl3pPr marL="914217" indent="0">
              <a:buNone/>
              <a:defRPr sz="1800" b="1"/>
            </a:lvl3pPr>
            <a:lvl4pPr marL="1371326" indent="0">
              <a:buNone/>
              <a:defRPr sz="1600" b="1"/>
            </a:lvl4pPr>
            <a:lvl5pPr marL="1828434" indent="0">
              <a:buNone/>
              <a:defRPr sz="1600" b="1"/>
            </a:lvl5pPr>
            <a:lvl6pPr marL="2285543" indent="0">
              <a:buNone/>
              <a:defRPr sz="1600" b="1"/>
            </a:lvl6pPr>
            <a:lvl7pPr marL="2742651" indent="0">
              <a:buNone/>
              <a:defRPr sz="1600" b="1"/>
            </a:lvl7pPr>
            <a:lvl8pPr marL="3199760" indent="0">
              <a:buNone/>
              <a:defRPr sz="1600" b="1"/>
            </a:lvl8pPr>
            <a:lvl9pPr marL="3656868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984" y="3390691"/>
            <a:ext cx="3340169" cy="616016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40211" y="2393284"/>
            <a:ext cx="3341481" cy="9974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09" indent="0">
              <a:buNone/>
              <a:defRPr sz="2000" b="1"/>
            </a:lvl2pPr>
            <a:lvl3pPr marL="914217" indent="0">
              <a:buNone/>
              <a:defRPr sz="1800" b="1"/>
            </a:lvl3pPr>
            <a:lvl4pPr marL="1371326" indent="0">
              <a:buNone/>
              <a:defRPr sz="1600" b="1"/>
            </a:lvl4pPr>
            <a:lvl5pPr marL="1828434" indent="0">
              <a:buNone/>
              <a:defRPr sz="1600" b="1"/>
            </a:lvl5pPr>
            <a:lvl6pPr marL="2285543" indent="0">
              <a:buNone/>
              <a:defRPr sz="1600" b="1"/>
            </a:lvl6pPr>
            <a:lvl7pPr marL="2742651" indent="0">
              <a:buNone/>
              <a:defRPr sz="1600" b="1"/>
            </a:lvl7pPr>
            <a:lvl8pPr marL="3199760" indent="0">
              <a:buNone/>
              <a:defRPr sz="1600" b="1"/>
            </a:lvl8pPr>
            <a:lvl9pPr marL="3656868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40211" y="3390691"/>
            <a:ext cx="3341481" cy="616016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7985" y="425693"/>
            <a:ext cx="2487081" cy="181166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55623" y="425693"/>
            <a:ext cx="4226068" cy="9125167"/>
          </a:xfrm>
        </p:spPr>
        <p:txBody>
          <a:bodyPr/>
          <a:lstStyle>
            <a:lvl1pPr>
              <a:defRPr sz="3199"/>
            </a:lvl1pPr>
            <a:lvl2pPr>
              <a:defRPr sz="2799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7985" y="2237362"/>
            <a:ext cx="2487081" cy="7313498"/>
          </a:xfrm>
        </p:spPr>
        <p:txBody>
          <a:bodyPr/>
          <a:lstStyle>
            <a:lvl1pPr marL="0" indent="0">
              <a:buNone/>
              <a:defRPr sz="1400"/>
            </a:lvl1pPr>
            <a:lvl2pPr marL="457109" indent="0">
              <a:buNone/>
              <a:defRPr sz="1200"/>
            </a:lvl2pPr>
            <a:lvl3pPr marL="914217" indent="0">
              <a:buNone/>
              <a:defRPr sz="1000"/>
            </a:lvl3pPr>
            <a:lvl4pPr marL="1371326" indent="0">
              <a:buNone/>
              <a:defRPr sz="900"/>
            </a:lvl4pPr>
            <a:lvl5pPr marL="1828434" indent="0">
              <a:buNone/>
              <a:defRPr sz="900"/>
            </a:lvl5pPr>
            <a:lvl6pPr marL="2285543" indent="0">
              <a:buNone/>
              <a:defRPr sz="900"/>
            </a:lvl6pPr>
            <a:lvl7pPr marL="2742651" indent="0">
              <a:buNone/>
              <a:defRPr sz="900"/>
            </a:lvl7pPr>
            <a:lvl8pPr marL="3199760" indent="0">
              <a:buNone/>
              <a:defRPr sz="900"/>
            </a:lvl8pPr>
            <a:lvl9pPr marL="3656868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1749" y="7484269"/>
            <a:ext cx="4535805" cy="88356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81749" y="955333"/>
            <a:ext cx="4535805" cy="6415088"/>
          </a:xfrm>
        </p:spPr>
        <p:txBody>
          <a:bodyPr/>
          <a:lstStyle>
            <a:lvl1pPr marL="0" indent="0">
              <a:buNone/>
              <a:defRPr sz="3199"/>
            </a:lvl1pPr>
            <a:lvl2pPr marL="457109" indent="0">
              <a:buNone/>
              <a:defRPr sz="2799"/>
            </a:lvl2pPr>
            <a:lvl3pPr marL="914217" indent="0">
              <a:buNone/>
              <a:defRPr sz="2400"/>
            </a:lvl3pPr>
            <a:lvl4pPr marL="1371326" indent="0">
              <a:buNone/>
              <a:defRPr sz="2000"/>
            </a:lvl4pPr>
            <a:lvl5pPr marL="1828434" indent="0">
              <a:buNone/>
              <a:defRPr sz="2000"/>
            </a:lvl5pPr>
            <a:lvl6pPr marL="2285543" indent="0">
              <a:buNone/>
              <a:defRPr sz="2000"/>
            </a:lvl6pPr>
            <a:lvl7pPr marL="2742651" indent="0">
              <a:buNone/>
              <a:defRPr sz="2000"/>
            </a:lvl7pPr>
            <a:lvl8pPr marL="3199760" indent="0">
              <a:buNone/>
              <a:defRPr sz="2000"/>
            </a:lvl8pPr>
            <a:lvl9pPr marL="3656868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1749" y="8367830"/>
            <a:ext cx="4535805" cy="1254802"/>
          </a:xfrm>
        </p:spPr>
        <p:txBody>
          <a:bodyPr/>
          <a:lstStyle>
            <a:lvl1pPr marL="0" indent="0">
              <a:buNone/>
              <a:defRPr sz="1400"/>
            </a:lvl1pPr>
            <a:lvl2pPr marL="457109" indent="0">
              <a:buNone/>
              <a:defRPr sz="1200"/>
            </a:lvl2pPr>
            <a:lvl3pPr marL="914217" indent="0">
              <a:buNone/>
              <a:defRPr sz="1000"/>
            </a:lvl3pPr>
            <a:lvl4pPr marL="1371326" indent="0">
              <a:buNone/>
              <a:defRPr sz="900"/>
            </a:lvl4pPr>
            <a:lvl5pPr marL="1828434" indent="0">
              <a:buNone/>
              <a:defRPr sz="900"/>
            </a:lvl5pPr>
            <a:lvl6pPr marL="2285543" indent="0">
              <a:buNone/>
              <a:defRPr sz="900"/>
            </a:lvl6pPr>
            <a:lvl7pPr marL="2742651" indent="0">
              <a:buNone/>
              <a:defRPr sz="900"/>
            </a:lvl7pPr>
            <a:lvl8pPr marL="3199760" indent="0">
              <a:buNone/>
              <a:defRPr sz="900"/>
            </a:lvl8pPr>
            <a:lvl9pPr marL="3656868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7984" y="428169"/>
            <a:ext cx="6803708" cy="17819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7984" y="2494757"/>
            <a:ext cx="6803708" cy="70561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7984" y="9909728"/>
            <a:ext cx="1763924" cy="56923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82889" y="9909728"/>
            <a:ext cx="2393897" cy="56923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17768" y="9909728"/>
            <a:ext cx="1763924" cy="56923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17" rtl="0" eaLnBrk="1" latinLnBrk="0" hangingPunct="1">
        <a:spcBef>
          <a:spcPct val="0"/>
        </a:spcBef>
        <a:buNone/>
        <a:defRPr sz="43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31" indent="-342831" algn="l" defTabSz="914217" rtl="0" eaLnBrk="1" latinLnBrk="0" hangingPunct="1">
        <a:spcBef>
          <a:spcPct val="20000"/>
        </a:spcBef>
        <a:buFont typeface="Arial" pitchFamily="34" charset="0"/>
        <a:buChar char="•"/>
        <a:defRPr sz="3199" kern="1200">
          <a:solidFill>
            <a:schemeClr val="tx1"/>
          </a:solidFill>
          <a:latin typeface="+mn-lt"/>
          <a:ea typeface="+mn-ea"/>
          <a:cs typeface="+mn-cs"/>
        </a:defRPr>
      </a:lvl1pPr>
      <a:lvl2pPr marL="742801" indent="-285693" algn="l" defTabSz="914217" rtl="0" eaLnBrk="1" latinLnBrk="0" hangingPunct="1">
        <a:spcBef>
          <a:spcPct val="20000"/>
        </a:spcBef>
        <a:buFont typeface="Arial" pitchFamily="34" charset="0"/>
        <a:buChar char="–"/>
        <a:defRPr sz="2799" kern="1200">
          <a:solidFill>
            <a:schemeClr val="tx1"/>
          </a:solidFill>
          <a:latin typeface="+mn-lt"/>
          <a:ea typeface="+mn-ea"/>
          <a:cs typeface="+mn-cs"/>
        </a:defRPr>
      </a:lvl2pPr>
      <a:lvl3pPr marL="1142771" indent="-228554" algn="l" defTabSz="914217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880" indent="-228554" algn="l" defTabSz="914217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6989" indent="-228554" algn="l" defTabSz="914217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097" indent="-228554" algn="l" defTabSz="91421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206" indent="-228554" algn="l" defTabSz="91421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314" indent="-228554" algn="l" defTabSz="91421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423" indent="-228554" algn="l" defTabSz="91421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2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09" algn="l" defTabSz="9142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17" algn="l" defTabSz="9142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326" algn="l" defTabSz="9142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434" algn="l" defTabSz="9142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543" algn="l" defTabSz="9142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651" algn="l" defTabSz="9142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760" algn="l" defTabSz="9142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6868" algn="l" defTabSz="9142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Relationship Id="rId9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>
            <a:extLst>
              <a:ext uri="{FF2B5EF4-FFF2-40B4-BE49-F238E27FC236}">
                <a16:creationId xmlns:a16="http://schemas.microsoft.com/office/drawing/2014/main" id="{0375105A-91A1-4A78-A0C8-A96DF352DB66}"/>
              </a:ext>
            </a:extLst>
          </p:cNvPr>
          <p:cNvSpPr txBox="1"/>
          <p:nvPr/>
        </p:nvSpPr>
        <p:spPr>
          <a:xfrm>
            <a:off x="427743" y="4242511"/>
            <a:ext cx="68565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 Figure 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quency of SNP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licoDAr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rkers distributed on the 21 chromosomes of bread wheat. The darker the green suggests the less the number of SNPs 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licoDArT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region.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 descr="A close up of text on a white surface&#10;&#10;Description automatically generated">
            <a:extLst>
              <a:ext uri="{FF2B5EF4-FFF2-40B4-BE49-F238E27FC236}">
                <a16:creationId xmlns:a16="http://schemas.microsoft.com/office/drawing/2014/main" id="{B60D3816-6E90-49E0-9C3B-B3C8A2F98D3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678"/>
          <a:stretch/>
        </p:blipFill>
        <p:spPr>
          <a:xfrm>
            <a:off x="350441" y="1154906"/>
            <a:ext cx="7011162" cy="253136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1EEAC91-45AB-426C-8385-8B64313D74FB}"/>
              </a:ext>
            </a:extLst>
          </p:cNvPr>
          <p:cNvSpPr txBox="1"/>
          <p:nvPr/>
        </p:nvSpPr>
        <p:spPr>
          <a:xfrm>
            <a:off x="1951037" y="969496"/>
            <a:ext cx="476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>
                <a:latin typeface="Arial" panose="020B0604020202020204" pitchFamily="34" charset="0"/>
                <a:cs typeface="Arial" panose="020B0604020202020204" pitchFamily="34" charset="0"/>
              </a:rPr>
              <a:t>SNP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899AF82-63ED-4C01-97BE-E7CD992597C2}"/>
              </a:ext>
            </a:extLst>
          </p:cNvPr>
          <p:cNvSpPr txBox="1"/>
          <p:nvPr/>
        </p:nvSpPr>
        <p:spPr>
          <a:xfrm>
            <a:off x="5303837" y="969496"/>
            <a:ext cx="8306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 err="1">
                <a:latin typeface="Arial" panose="020B0604020202020204" pitchFamily="34" charset="0"/>
                <a:cs typeface="Arial" panose="020B0604020202020204" pitchFamily="34" charset="0"/>
              </a:rPr>
              <a:t>silicoDArT</a:t>
            </a:r>
            <a:endParaRPr lang="en-AU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13000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503238" y="697706"/>
            <a:ext cx="6638082" cy="3201132"/>
            <a:chOff x="111427" y="267609"/>
            <a:chExt cx="7426533" cy="3602716"/>
          </a:xfrm>
        </p:grpSpPr>
        <p:pic>
          <p:nvPicPr>
            <p:cNvPr id="2051" name="Picture 3" descr="C:\Users\yangn\Documents\###Project folder\Results\AS STB\#Association analysis R\snpLD_plot.png"/>
            <p:cNvPicPr>
              <a:picLocks noChangeAspect="1" noChangeArrowheads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79"/>
            <a:stretch/>
          </p:blipFill>
          <p:spPr bwMode="auto">
            <a:xfrm>
              <a:off x="111427" y="669925"/>
              <a:ext cx="7426533" cy="32004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TextBox 6"/>
            <p:cNvSpPr txBox="1"/>
            <p:nvPr/>
          </p:nvSpPr>
          <p:spPr>
            <a:xfrm>
              <a:off x="111427" y="267609"/>
              <a:ext cx="1278761" cy="311749"/>
            </a:xfrm>
            <a:prstGeom prst="rect">
              <a:avLst/>
            </a:prstGeom>
            <a:noFill/>
            <a:ln w="3175">
              <a:noFill/>
            </a:ln>
          </p:spPr>
          <p:txBody>
            <a:bodyPr vert="horz"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a)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NP</a:t>
              </a:r>
              <a:endParaRPr lang="en-AU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503237" y="4355307"/>
            <a:ext cx="6640234" cy="3200400"/>
            <a:chOff x="111426" y="3926032"/>
            <a:chExt cx="7428941" cy="3601893"/>
          </a:xfrm>
        </p:grpSpPr>
        <p:pic>
          <p:nvPicPr>
            <p:cNvPr id="2050" name="Picture 2" descr="C:\Users\yangn\Documents\###Project folder\Results\AS STB\#Association analysis R\pavLD_plot.png"/>
            <p:cNvPicPr>
              <a:picLocks noChangeAspect="1" noChangeArrowheads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6"/>
            <a:stretch/>
          </p:blipFill>
          <p:spPr bwMode="auto">
            <a:xfrm>
              <a:off x="111426" y="4327525"/>
              <a:ext cx="7428941" cy="32004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TextBox 7"/>
            <p:cNvSpPr txBox="1"/>
            <p:nvPr/>
          </p:nvSpPr>
          <p:spPr>
            <a:xfrm>
              <a:off x="111426" y="3926032"/>
              <a:ext cx="1449264" cy="311749"/>
            </a:xfrm>
            <a:prstGeom prst="rect">
              <a:avLst/>
            </a:prstGeom>
            <a:noFill/>
            <a:ln w="3175">
              <a:noFill/>
            </a:ln>
          </p:spPr>
          <p:txBody>
            <a:bodyPr vert="horz"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b)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silicoDArT</a:t>
              </a:r>
              <a:endParaRPr lang="en-AU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DDF62252-4147-401F-AD51-9ED3A5DF2105}"/>
              </a:ext>
            </a:extLst>
          </p:cNvPr>
          <p:cNvSpPr txBox="1"/>
          <p:nvPr/>
        </p:nvSpPr>
        <p:spPr>
          <a:xfrm>
            <a:off x="427743" y="8357311"/>
            <a:ext cx="68565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 Figure 2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D heatmap of SNP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licoDAr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rkers on the 21 chromosomes of bread wheat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quare is used to calculate the linkage disequilibrium. Blue color indicates low linkage while red color indicates high linkage.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1F164C1-D0D3-4324-863D-1070976D5E9F}"/>
              </a:ext>
            </a:extLst>
          </p:cNvPr>
          <p:cNvSpPr txBox="1"/>
          <p:nvPr/>
        </p:nvSpPr>
        <p:spPr>
          <a:xfrm>
            <a:off x="6721157" y="7231856"/>
            <a:ext cx="72000" cy="36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AU" dirty="0">
              <a:solidFill>
                <a:schemeClr val="bg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5DA70D2-4F90-4986-88D2-224040695143}"/>
              </a:ext>
            </a:extLst>
          </p:cNvPr>
          <p:cNvSpPr txBox="1"/>
          <p:nvPr/>
        </p:nvSpPr>
        <p:spPr>
          <a:xfrm>
            <a:off x="6638572" y="7175597"/>
            <a:ext cx="2471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500" i="1" dirty="0">
                <a:latin typeface="Arial" panose="020B0604020202020204" pitchFamily="34" charset="0"/>
                <a:cs typeface="Arial" panose="020B0604020202020204" pitchFamily="34" charset="0"/>
              </a:rPr>
              <a:t>r </a:t>
            </a:r>
            <a:r>
              <a:rPr lang="en-AU" sz="5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EA07CB2-E2C8-4C35-BA51-9E376A1ECCA0}"/>
              </a:ext>
            </a:extLst>
          </p:cNvPr>
          <p:cNvSpPr txBox="1"/>
          <p:nvPr/>
        </p:nvSpPr>
        <p:spPr>
          <a:xfrm>
            <a:off x="6638572" y="3562826"/>
            <a:ext cx="432000" cy="144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3920597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558873" y="5319388"/>
            <a:ext cx="6573061" cy="1977428"/>
            <a:chOff x="206460" y="288926"/>
            <a:chExt cx="7354803" cy="2496478"/>
          </a:xfrm>
        </p:grpSpPr>
        <p:pic>
          <p:nvPicPr>
            <p:cNvPr id="1027" name="Picture 3" descr="C:\Users\yangn\Documents\###Project folder\Results\AS STB\#Association analysis R\LDdecay_allsnp.png"/>
            <p:cNvPicPr>
              <a:picLocks noChangeAspect="1" noChangeArrowheads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134" r="1907" b="48863"/>
            <a:stretch/>
          </p:blipFill>
          <p:spPr bwMode="auto">
            <a:xfrm>
              <a:off x="206460" y="288926"/>
              <a:ext cx="7354803" cy="249647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8" name="Group 7"/>
            <p:cNvGrpSpPr/>
            <p:nvPr/>
          </p:nvGrpSpPr>
          <p:grpSpPr>
            <a:xfrm>
              <a:off x="6386671" y="700759"/>
              <a:ext cx="913242" cy="291422"/>
              <a:chOff x="6142831" y="717269"/>
              <a:chExt cx="913242" cy="291422"/>
            </a:xfrm>
          </p:grpSpPr>
          <p:sp>
            <p:nvSpPr>
              <p:cNvPr id="4" name="TextBox 3"/>
              <p:cNvSpPr txBox="1"/>
              <p:nvPr/>
            </p:nvSpPr>
            <p:spPr>
              <a:xfrm>
                <a:off x="6371431" y="717269"/>
                <a:ext cx="684642" cy="2914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A+B+D</a:t>
                </a:r>
                <a:endParaRPr lang="en-AU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" name="Straight Connector 5"/>
              <p:cNvCxnSpPr/>
              <p:nvPr/>
            </p:nvCxnSpPr>
            <p:spPr>
              <a:xfrm>
                <a:off x="6142831" y="873083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" name="TextBox 17"/>
            <p:cNvSpPr txBox="1"/>
            <p:nvPr/>
          </p:nvSpPr>
          <p:spPr>
            <a:xfrm>
              <a:off x="953611" y="493554"/>
              <a:ext cx="1248727" cy="363596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txBody>
            <a:bodyPr vert="horz" wrap="square" rtlCol="0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NP+silicoDArT</a:t>
              </a:r>
              <a:endParaRPr lang="en-AU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702349" y="493552"/>
              <a:ext cx="1248727" cy="363596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txBody>
            <a:bodyPr vert="horz" wrap="square" rtlCol="0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NP+silicoDArT</a:t>
              </a:r>
              <a:endParaRPr lang="en-AU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558873" y="603166"/>
            <a:ext cx="6573061" cy="1973598"/>
            <a:chOff x="206460" y="2879725"/>
            <a:chExt cx="7354803" cy="2491642"/>
          </a:xfrm>
        </p:grpSpPr>
        <p:pic>
          <p:nvPicPr>
            <p:cNvPr id="1028" name="Picture 4" descr="C:\Users\yangn\Documents\###Project folder\Results\AS STB\#Association analysis R\LDdecay_allpav.png"/>
            <p:cNvPicPr>
              <a:picLocks noChangeAspect="1" noChangeArrowheads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981" r="1907" b="49099"/>
            <a:stretch/>
          </p:blipFill>
          <p:spPr bwMode="auto">
            <a:xfrm>
              <a:off x="206460" y="2879725"/>
              <a:ext cx="7354803" cy="249164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2" name="Group 11"/>
            <p:cNvGrpSpPr/>
            <p:nvPr/>
          </p:nvGrpSpPr>
          <p:grpSpPr>
            <a:xfrm>
              <a:off x="6386671" y="3310069"/>
              <a:ext cx="913242" cy="291422"/>
              <a:chOff x="6142831" y="726889"/>
              <a:chExt cx="913242" cy="291422"/>
            </a:xfrm>
          </p:grpSpPr>
          <p:sp>
            <p:nvSpPr>
              <p:cNvPr id="13" name="TextBox 12"/>
              <p:cNvSpPr txBox="1"/>
              <p:nvPr/>
            </p:nvSpPr>
            <p:spPr>
              <a:xfrm>
                <a:off x="6371431" y="726889"/>
                <a:ext cx="684642" cy="2914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A+B+D</a:t>
                </a:r>
                <a:endParaRPr lang="en-AU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" name="Straight Connector 13"/>
              <p:cNvCxnSpPr/>
              <p:nvPr/>
            </p:nvCxnSpPr>
            <p:spPr>
              <a:xfrm>
                <a:off x="6142831" y="873083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" name="TextBox 19"/>
            <p:cNvSpPr txBox="1"/>
            <p:nvPr/>
          </p:nvSpPr>
          <p:spPr>
            <a:xfrm>
              <a:off x="953612" y="3093244"/>
              <a:ext cx="773604" cy="310786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txBody>
            <a:bodyPr vert="horz"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NP</a:t>
              </a:r>
              <a:endParaRPr lang="en-AU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702350" y="3093244"/>
              <a:ext cx="773604" cy="310786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txBody>
            <a:bodyPr vert="horz"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NP</a:t>
              </a:r>
              <a:endParaRPr lang="en-AU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551647" y="2805316"/>
            <a:ext cx="6579521" cy="2285520"/>
            <a:chOff x="199232" y="5546725"/>
            <a:chExt cx="7362032" cy="2885440"/>
          </a:xfrm>
        </p:grpSpPr>
        <p:pic>
          <p:nvPicPr>
            <p:cNvPr id="1026" name="Picture 2" descr="C:\Users\yangn\Documents\###Project folder\Results\AS STB\#Association analysis R\LDdecay_all.png"/>
            <p:cNvPicPr>
              <a:picLocks noChangeAspect="1" noChangeArrowheads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327" r="1811" b="42126"/>
            <a:stretch/>
          </p:blipFill>
          <p:spPr bwMode="auto">
            <a:xfrm>
              <a:off x="199232" y="5546725"/>
              <a:ext cx="7362032" cy="28854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5" name="Group 14"/>
            <p:cNvGrpSpPr/>
            <p:nvPr/>
          </p:nvGrpSpPr>
          <p:grpSpPr>
            <a:xfrm>
              <a:off x="6379051" y="5938969"/>
              <a:ext cx="913242" cy="291422"/>
              <a:chOff x="6142831" y="726889"/>
              <a:chExt cx="913242" cy="291422"/>
            </a:xfrm>
          </p:grpSpPr>
          <p:sp>
            <p:nvSpPr>
              <p:cNvPr id="16" name="TextBox 15"/>
              <p:cNvSpPr txBox="1"/>
              <p:nvPr/>
            </p:nvSpPr>
            <p:spPr>
              <a:xfrm>
                <a:off x="6371431" y="726889"/>
                <a:ext cx="684642" cy="2914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A+B+D</a:t>
                </a:r>
                <a:endParaRPr lang="en-AU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" name="Straight Connector 16"/>
              <p:cNvCxnSpPr/>
              <p:nvPr/>
            </p:nvCxnSpPr>
            <p:spPr>
              <a:xfrm>
                <a:off x="6142831" y="873083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" name="TextBox 21"/>
            <p:cNvSpPr txBox="1"/>
            <p:nvPr/>
          </p:nvSpPr>
          <p:spPr>
            <a:xfrm>
              <a:off x="943175" y="5742464"/>
              <a:ext cx="886194" cy="363596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txBody>
            <a:bodyPr vert="horz" wrap="square" rtlCol="0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licoDArT</a:t>
              </a:r>
              <a:endParaRPr lang="en-AU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695031" y="5742464"/>
              <a:ext cx="886194" cy="363596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txBody>
            <a:bodyPr vert="horz" wrap="square" rtlCol="0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licoDArT</a:t>
              </a:r>
              <a:endParaRPr lang="en-AU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8B8165B5-E36B-480C-91D1-CAF43D00DD51}"/>
              </a:ext>
            </a:extLst>
          </p:cNvPr>
          <p:cNvSpPr txBox="1"/>
          <p:nvPr/>
        </p:nvSpPr>
        <p:spPr>
          <a:xfrm>
            <a:off x="427743" y="7823911"/>
            <a:ext cx="685655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 Figure 3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 of SNP and/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licoDAr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rkers to calculate the average genetic distance of LD decay on A, B, D genome, and whole genome of bread wheat. The grey dotted lines represent LD is equal to 0.1, the black dotted lines represent LD is equal to 0.2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P only markers were used for the decay of LD calculation;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licoDAr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ly markers were used for the decay of LD calculation;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P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licoDAr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rkers were combined for the decay of LD calculation.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6F64226-3545-4307-8AE6-F7974D8C764C}"/>
              </a:ext>
            </a:extLst>
          </p:cNvPr>
          <p:cNvSpPr txBox="1"/>
          <p:nvPr/>
        </p:nvSpPr>
        <p:spPr>
          <a:xfrm>
            <a:off x="174309" y="1345029"/>
            <a:ext cx="3845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AU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B49DC62-801B-4E18-839D-DA4FD8154FF2}"/>
              </a:ext>
            </a:extLst>
          </p:cNvPr>
          <p:cNvSpPr txBox="1"/>
          <p:nvPr/>
        </p:nvSpPr>
        <p:spPr>
          <a:xfrm>
            <a:off x="174309" y="3527803"/>
            <a:ext cx="3845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AU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CEC5495-7653-42AF-8CFB-5A5A9D13227B}"/>
              </a:ext>
            </a:extLst>
          </p:cNvPr>
          <p:cNvSpPr txBox="1"/>
          <p:nvPr/>
        </p:nvSpPr>
        <p:spPr>
          <a:xfrm>
            <a:off x="174309" y="6044910"/>
            <a:ext cx="3845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en-AU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77377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1A9195B-4A7F-4AB2-B0B5-64F665A398C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58" r="-1" b="9072"/>
          <a:stretch/>
        </p:blipFill>
        <p:spPr>
          <a:xfrm>
            <a:off x="179006" y="4507706"/>
            <a:ext cx="4688441" cy="1828800"/>
          </a:xfrm>
          <a:prstGeom prst="rect">
            <a:avLst/>
          </a:prstGeom>
        </p:spPr>
      </p:pic>
      <p:pic>
        <p:nvPicPr>
          <p:cNvPr id="6" name="Picture 5" descr="Chart, line chart&#10;&#10;Description automatically generated">
            <a:extLst>
              <a:ext uri="{FF2B5EF4-FFF2-40B4-BE49-F238E27FC236}">
                <a16:creationId xmlns:a16="http://schemas.microsoft.com/office/drawing/2014/main" id="{5488DA60-A483-4573-A71F-4909980B818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80037" y="4516392"/>
            <a:ext cx="1828804" cy="182880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A7E4E1B-C48A-42DB-86EA-4CE78B2BCBDC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57" t="-1" b="1494"/>
          <a:stretch/>
        </p:blipFill>
        <p:spPr>
          <a:xfrm>
            <a:off x="179006" y="6717506"/>
            <a:ext cx="4688441" cy="1981200"/>
          </a:xfrm>
          <a:prstGeom prst="rect">
            <a:avLst/>
          </a:prstGeom>
        </p:spPr>
      </p:pic>
      <p:pic>
        <p:nvPicPr>
          <p:cNvPr id="9" name="Picture 8" descr="Chart, line chart&#10;&#10;Description automatically generated">
            <a:extLst>
              <a:ext uri="{FF2B5EF4-FFF2-40B4-BE49-F238E27FC236}">
                <a16:creationId xmlns:a16="http://schemas.microsoft.com/office/drawing/2014/main" id="{CC10D5BE-4580-45AC-ABE3-9CB1F47DA6D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80037" y="6869902"/>
            <a:ext cx="1828804" cy="1828804"/>
          </a:xfrm>
          <a:prstGeom prst="rect">
            <a:avLst/>
          </a:prstGeom>
        </p:spPr>
      </p:pic>
      <p:pic>
        <p:nvPicPr>
          <p:cNvPr id="10" name="Picture 9" descr="Chart, line chart&#10;&#10;Description automatically generated">
            <a:extLst>
              <a:ext uri="{FF2B5EF4-FFF2-40B4-BE49-F238E27FC236}">
                <a16:creationId xmlns:a16="http://schemas.microsoft.com/office/drawing/2014/main" id="{BD14F8E6-144F-4551-BBD6-F290D588309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80037" y="316706"/>
            <a:ext cx="1828804" cy="1828804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C48BDB1-A4EE-408E-8C5F-EC17492C36BF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57"/>
          <a:stretch/>
        </p:blipFill>
        <p:spPr>
          <a:xfrm>
            <a:off x="247459" y="316706"/>
            <a:ext cx="4688441" cy="2011262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32C47286-3AD7-4CE8-9223-6CE7EAB47D0C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57" t="3608" b="5123"/>
          <a:stretch/>
        </p:blipFill>
        <p:spPr>
          <a:xfrm>
            <a:off x="247459" y="2374106"/>
            <a:ext cx="4688441" cy="1835615"/>
          </a:xfrm>
          <a:prstGeom prst="rect">
            <a:avLst/>
          </a:prstGeom>
        </p:spPr>
      </p:pic>
      <p:pic>
        <p:nvPicPr>
          <p:cNvPr id="14" name="Picture 13" descr="Chart, line chart&#10;&#10;Description automatically generated">
            <a:extLst>
              <a:ext uri="{FF2B5EF4-FFF2-40B4-BE49-F238E27FC236}">
                <a16:creationId xmlns:a16="http://schemas.microsoft.com/office/drawing/2014/main" id="{E0BAC06A-BA6A-4EAF-8284-61DE17CFEBA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80037" y="2355961"/>
            <a:ext cx="1828804" cy="1828804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D49FE0D6-205E-4C94-84B3-F7296139D4BB}"/>
              </a:ext>
            </a:extLst>
          </p:cNvPr>
          <p:cNvSpPr txBox="1"/>
          <p:nvPr/>
        </p:nvSpPr>
        <p:spPr>
          <a:xfrm>
            <a:off x="731837" y="392906"/>
            <a:ext cx="859866" cy="246169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HT 2016</a:t>
            </a:r>
            <a:endParaRPr lang="en-AU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BE36AEC-836E-4A03-941A-C382FEF0754D}"/>
              </a:ext>
            </a:extLst>
          </p:cNvPr>
          <p:cNvSpPr txBox="1"/>
          <p:nvPr/>
        </p:nvSpPr>
        <p:spPr>
          <a:xfrm>
            <a:off x="731837" y="2404168"/>
            <a:ext cx="859866" cy="246169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HT 2017</a:t>
            </a:r>
            <a:endParaRPr lang="en-AU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B857060-15BE-496F-8438-6DBD88121E17}"/>
              </a:ext>
            </a:extLst>
          </p:cNvPr>
          <p:cNvSpPr txBox="1"/>
          <p:nvPr/>
        </p:nvSpPr>
        <p:spPr>
          <a:xfrm>
            <a:off x="731837" y="4632711"/>
            <a:ext cx="990600" cy="246221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Zadoks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 2015</a:t>
            </a:r>
            <a:endParaRPr lang="en-AU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7ED66BF-37EA-4A91-A617-668D532D8619}"/>
              </a:ext>
            </a:extLst>
          </p:cNvPr>
          <p:cNvSpPr txBox="1"/>
          <p:nvPr/>
        </p:nvSpPr>
        <p:spPr>
          <a:xfrm>
            <a:off x="727431" y="6819149"/>
            <a:ext cx="995005" cy="246221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Zadoks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 2016</a:t>
            </a:r>
            <a:endParaRPr lang="en-AU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4698D39-3961-4848-B99C-1A63AB6DC9EF}"/>
              </a:ext>
            </a:extLst>
          </p:cNvPr>
          <p:cNvSpPr txBox="1"/>
          <p:nvPr/>
        </p:nvSpPr>
        <p:spPr>
          <a:xfrm>
            <a:off x="427743" y="8902456"/>
            <a:ext cx="68565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 Figure 4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WAS analysis of the traits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 Height (HT) and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adoks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al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nhattan and Q-Q plots for marker-trait association analysis across the whole genome of bread wheat. Orange solid dot represents the SNP marker, while dark-green solid dot represents the </a:t>
            </a:r>
            <a:r>
              <a:rPr lang="en-A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licoDArT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rker.</a:t>
            </a:r>
          </a:p>
        </p:txBody>
      </p:sp>
    </p:spTree>
    <p:extLst>
      <p:ext uri="{BB962C8B-B14F-4D97-AF65-F5344CB8AC3E}">
        <p14:creationId xmlns:p14="http://schemas.microsoft.com/office/powerpoint/2010/main" val="10719509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150f9a60-f00b-4b5e-985f-18ee7339d567">
      <Terms xmlns="http://schemas.microsoft.com/office/infopath/2007/PartnerControls"/>
    </lcf76f155ced4ddcb4097134ff3c332f>
    <TaxCatchAll xmlns="68babae2-2ab8-4196-914c-ebc6df0733eb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A1EAB04E94F9418A71BC26CC31B613" ma:contentTypeVersion="16" ma:contentTypeDescription="Create a new document." ma:contentTypeScope="" ma:versionID="0a04c5d80b7f0b5cef6d15ec1ae1221a">
  <xsd:schema xmlns:xsd="http://www.w3.org/2001/XMLSchema" xmlns:xs="http://www.w3.org/2001/XMLSchema" xmlns:p="http://schemas.microsoft.com/office/2006/metadata/properties" xmlns:ns2="150f9a60-f00b-4b5e-985f-18ee7339d567" xmlns:ns3="68babae2-2ab8-4196-914c-ebc6df0733eb" targetNamespace="http://schemas.microsoft.com/office/2006/metadata/properties" ma:root="true" ma:fieldsID="dd5313fa720de700d743accdf97b3643" ns2:_="" ns3:_="">
    <xsd:import namespace="150f9a60-f00b-4b5e-985f-18ee7339d567"/>
    <xsd:import namespace="68babae2-2ab8-4196-914c-ebc6df0733e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ServiceLocation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50f9a60-f00b-4b5e-985f-18ee7339d56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6444c108-d34f-4c01-85d9-27842d74072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LengthInSeconds" ma:index="23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8babae2-2ab8-4196-914c-ebc6df0733eb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2182e60b-9af4-4ac1-9946-2bb835412083}" ma:internalName="TaxCatchAll" ma:showField="CatchAllData" ma:web="68babae2-2ab8-4196-914c-ebc6df0733eb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AA767C64-4063-420B-9D08-4A7484B4F4B4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C6CB56FA-F022-4CA9-A60C-BFE36F05F0B1}">
  <ds:schemaRefs>
    <ds:schemaRef ds:uri="http://schemas.microsoft.com/office/2006/documentManagement/types"/>
    <ds:schemaRef ds:uri="http://schemas.microsoft.com/office/2006/metadata/properties"/>
    <ds:schemaRef ds:uri="68babae2-2ab8-4196-914c-ebc6df0733eb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150f9a60-f00b-4b5e-985f-18ee7339d567"/>
    <ds:schemaRef ds:uri="http://www.w3.org/XML/1998/namespace"/>
    <ds:schemaRef ds:uri="http://purl.org/dc/elements/1.1/"/>
  </ds:schemaRefs>
</ds:datastoreItem>
</file>

<file path=customXml/itemProps3.xml><?xml version="1.0" encoding="utf-8"?>
<ds:datastoreItem xmlns:ds="http://schemas.openxmlformats.org/officeDocument/2006/customXml" ds:itemID="{FCAED929-EA12-46F7-BCCF-123A9B9088F1}"/>
</file>

<file path=docProps/app.xml><?xml version="1.0" encoding="utf-8"?>
<Properties xmlns="http://schemas.openxmlformats.org/officeDocument/2006/extended-properties" xmlns:vt="http://schemas.openxmlformats.org/officeDocument/2006/docPropsVTypes">
  <TotalTime>63626</TotalTime>
  <Words>288</Words>
  <Application>Microsoft Office PowerPoint</Application>
  <PresentationFormat>Custom</PresentationFormat>
  <Paragraphs>27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ngn</dc:creator>
  <cp:lastModifiedBy>Nannan Yang</cp:lastModifiedBy>
  <cp:revision>552</cp:revision>
  <cp:lastPrinted>2019-05-03T05:50:03Z</cp:lastPrinted>
  <dcterms:created xsi:type="dcterms:W3CDTF">2006-08-16T00:00:00Z</dcterms:created>
  <dcterms:modified xsi:type="dcterms:W3CDTF">2022-06-03T00:28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A1EAB04E94F9418A71BC26CC31B613</vt:lpwstr>
  </property>
  <property fmtid="{D5CDD505-2E9C-101B-9397-08002B2CF9AE}" pid="3" name="Order">
    <vt:r8>23000</vt:r8>
  </property>
  <property fmtid="{D5CDD505-2E9C-101B-9397-08002B2CF9AE}" pid="4" name="MediaServiceImageTags">
    <vt:lpwstr/>
  </property>
</Properties>
</file>